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42113" cy="9872663"/>
  <p:defaultTextStyle>
    <a:defPPr>
      <a:defRPr lang="nl-NL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18" d="100"/>
          <a:sy n="118" d="100"/>
        </p:scale>
        <p:origin x="2204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6D42FD-3D60-4D67-882C-CCA186499040}" type="datetimeFigureOut">
              <a:rPr lang="en-US"/>
              <a:pPr>
                <a:defRPr/>
              </a:pPr>
              <a:t>4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DB5176-9DCD-423D-9B82-93D81A1216B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B69277-E272-41CA-8A83-52BEA1F79F22}" type="datetimeFigureOut">
              <a:rPr lang="en-US"/>
              <a:pPr>
                <a:defRPr/>
              </a:pPr>
              <a:t>4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F5A969-3357-4C1B-9380-D977AF4A02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459113-8780-4468-80D0-F1A9C5C242D5}" type="datetimeFigureOut">
              <a:rPr lang="en-US"/>
              <a:pPr>
                <a:defRPr/>
              </a:pPr>
              <a:t>4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BBD9DA-77C2-4FDD-8043-5C112E45160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286C46-9497-4430-9F03-EE56078F2186}" type="datetimeFigureOut">
              <a:rPr lang="en-US"/>
              <a:pPr>
                <a:defRPr/>
              </a:pPr>
              <a:t>4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561B09-73CE-4ECC-B8FC-BD7078EB8FE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C20566-482E-4E97-988D-6AEA6820F750}" type="datetimeFigureOut">
              <a:rPr lang="en-US"/>
              <a:pPr>
                <a:defRPr/>
              </a:pPr>
              <a:t>4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B646E4-19C7-4024-8D31-3F671DC5A2C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466D93-96B8-42FE-A9F0-65149AFC47A2}" type="datetimeFigureOut">
              <a:rPr lang="en-US"/>
              <a:pPr>
                <a:defRPr/>
              </a:pPr>
              <a:t>4/29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BCB018-05EF-4590-ADCC-7BC7F9135E4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D499EF-8E78-40FC-B9CC-0166B5A0F466}" type="datetimeFigureOut">
              <a:rPr lang="en-US"/>
              <a:pPr>
                <a:defRPr/>
              </a:pPr>
              <a:t>4/29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49EB1E-B3B0-4F96-A8EB-56E0A52FCD7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B574DF-05AC-48E2-8FD8-CFCC1D953A9E}" type="datetimeFigureOut">
              <a:rPr lang="en-US"/>
              <a:pPr>
                <a:defRPr/>
              </a:pPr>
              <a:t>4/29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253141-9CCA-4C6B-9929-6AB04BA3261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0BF1F0-6ACD-4A08-B5E9-E1794F26B2EC}" type="datetimeFigureOut">
              <a:rPr lang="en-US"/>
              <a:pPr>
                <a:defRPr/>
              </a:pPr>
              <a:t>4/29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08DAB4-9FB0-40EE-AEFB-72624EB1227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FE24C2-C379-4983-BD1B-0AE96E5DEB77}" type="datetimeFigureOut">
              <a:rPr lang="en-US"/>
              <a:pPr>
                <a:defRPr/>
              </a:pPr>
              <a:t>4/29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B8797B-209B-4755-960A-1AA9EBCEC96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4293CE-9A13-4783-9D8A-9CDE1388B516}" type="datetimeFigureOut">
              <a:rPr lang="en-US"/>
              <a:pPr>
                <a:defRPr/>
              </a:pPr>
              <a:t>4/29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38EBE4-0234-47DE-9824-D3784FE75FA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F4CF9CA2-7415-409E-BC78-39CF132DE68F}" type="datetimeFigureOut">
              <a:rPr lang="en-US"/>
              <a:pPr>
                <a:defRPr/>
              </a:pPr>
              <a:t>4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C9BF42F1-A255-49EA-B160-B2F4F774D82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reeform 7"/>
          <p:cNvSpPr>
            <a:spLocks noEditPoints="1"/>
          </p:cNvSpPr>
          <p:nvPr/>
        </p:nvSpPr>
        <p:spPr bwMode="auto">
          <a:xfrm>
            <a:off x="3331041" y="2687638"/>
            <a:ext cx="465274" cy="50800"/>
          </a:xfrm>
          <a:custGeom>
            <a:avLst/>
            <a:gdLst>
              <a:gd name="T0" fmla="*/ 290 w 3808"/>
              <a:gd name="T1" fmla="*/ 19 h 400"/>
              <a:gd name="T2" fmla="*/ 26 w 3808"/>
              <a:gd name="T3" fmla="*/ 19 h 400"/>
              <a:gd name="T4" fmla="*/ 23 w 3808"/>
              <a:gd name="T5" fmla="*/ 16 h 400"/>
              <a:gd name="T6" fmla="*/ 26 w 3808"/>
              <a:gd name="T7" fmla="*/ 13 h 400"/>
              <a:gd name="T8" fmla="*/ 290 w 3808"/>
              <a:gd name="T9" fmla="*/ 13 h 400"/>
              <a:gd name="T10" fmla="*/ 293 w 3808"/>
              <a:gd name="T11" fmla="*/ 16 h 400"/>
              <a:gd name="T12" fmla="*/ 290 w 3808"/>
              <a:gd name="T13" fmla="*/ 19 h 400"/>
              <a:gd name="T14" fmla="*/ 31 w 3808"/>
              <a:gd name="T15" fmla="*/ 32 h 400"/>
              <a:gd name="T16" fmla="*/ 0 w 3808"/>
              <a:gd name="T17" fmla="*/ 16 h 400"/>
              <a:gd name="T18" fmla="*/ 31 w 3808"/>
              <a:gd name="T19" fmla="*/ 0 h 400"/>
              <a:gd name="T20" fmla="*/ 31 w 3808"/>
              <a:gd name="T21" fmla="*/ 32 h 4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3808"/>
              <a:gd name="T34" fmla="*/ 0 h 400"/>
              <a:gd name="T35" fmla="*/ 3808 w 3808"/>
              <a:gd name="T36" fmla="*/ 400 h 4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3808" h="400">
                <a:moveTo>
                  <a:pt x="3775" y="234"/>
                </a:moveTo>
                <a:lnTo>
                  <a:pt x="333" y="234"/>
                </a:lnTo>
                <a:cubicBezTo>
                  <a:pt x="315" y="234"/>
                  <a:pt x="300" y="219"/>
                  <a:pt x="300" y="200"/>
                </a:cubicBezTo>
                <a:cubicBezTo>
                  <a:pt x="300" y="182"/>
                  <a:pt x="315" y="167"/>
                  <a:pt x="333" y="167"/>
                </a:cubicBezTo>
                <a:lnTo>
                  <a:pt x="3775" y="167"/>
                </a:lnTo>
                <a:cubicBezTo>
                  <a:pt x="3794" y="167"/>
                  <a:pt x="3808" y="182"/>
                  <a:pt x="3808" y="200"/>
                </a:cubicBezTo>
                <a:cubicBezTo>
                  <a:pt x="3808" y="219"/>
                  <a:pt x="3794" y="234"/>
                  <a:pt x="3775" y="234"/>
                </a:cubicBezTo>
                <a:close/>
                <a:moveTo>
                  <a:pt x="400" y="400"/>
                </a:moveTo>
                <a:lnTo>
                  <a:pt x="0" y="200"/>
                </a:lnTo>
                <a:lnTo>
                  <a:pt x="400" y="0"/>
                </a:lnTo>
                <a:lnTo>
                  <a:pt x="400" y="40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" name="Freeform 8"/>
          <p:cNvSpPr>
            <a:spLocks noEditPoints="1"/>
          </p:cNvSpPr>
          <p:nvPr/>
        </p:nvSpPr>
        <p:spPr bwMode="auto">
          <a:xfrm>
            <a:off x="2403669" y="2687638"/>
            <a:ext cx="465274" cy="50800"/>
          </a:xfrm>
          <a:custGeom>
            <a:avLst/>
            <a:gdLst>
              <a:gd name="T0" fmla="*/ 3 w 7633"/>
              <a:gd name="T1" fmla="*/ 13 h 800"/>
              <a:gd name="T2" fmla="*/ 267 w 7633"/>
              <a:gd name="T3" fmla="*/ 13 h 800"/>
              <a:gd name="T4" fmla="*/ 270 w 7633"/>
              <a:gd name="T5" fmla="*/ 16 h 800"/>
              <a:gd name="T6" fmla="*/ 267 w 7633"/>
              <a:gd name="T7" fmla="*/ 19 h 800"/>
              <a:gd name="T8" fmla="*/ 3 w 7633"/>
              <a:gd name="T9" fmla="*/ 19 h 800"/>
              <a:gd name="T10" fmla="*/ 0 w 7633"/>
              <a:gd name="T11" fmla="*/ 16 h 800"/>
              <a:gd name="T12" fmla="*/ 3 w 7633"/>
              <a:gd name="T13" fmla="*/ 13 h 800"/>
              <a:gd name="T14" fmla="*/ 262 w 7633"/>
              <a:gd name="T15" fmla="*/ 0 h 800"/>
              <a:gd name="T16" fmla="*/ 293 w 7633"/>
              <a:gd name="T17" fmla="*/ 16 h 800"/>
              <a:gd name="T18" fmla="*/ 262 w 7633"/>
              <a:gd name="T19" fmla="*/ 32 h 800"/>
              <a:gd name="T20" fmla="*/ 262 w 7633"/>
              <a:gd name="T21" fmla="*/ 0 h 8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7633"/>
              <a:gd name="T34" fmla="*/ 0 h 800"/>
              <a:gd name="T35" fmla="*/ 7633 w 7633"/>
              <a:gd name="T36" fmla="*/ 800 h 8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7633" h="800">
                <a:moveTo>
                  <a:pt x="66" y="334"/>
                </a:moveTo>
                <a:lnTo>
                  <a:pt x="6966" y="334"/>
                </a:lnTo>
                <a:cubicBezTo>
                  <a:pt x="7003" y="334"/>
                  <a:pt x="7033" y="364"/>
                  <a:pt x="7033" y="400"/>
                </a:cubicBezTo>
                <a:cubicBezTo>
                  <a:pt x="7033" y="437"/>
                  <a:pt x="7003" y="467"/>
                  <a:pt x="6966" y="467"/>
                </a:cubicBezTo>
                <a:lnTo>
                  <a:pt x="66" y="467"/>
                </a:lnTo>
                <a:cubicBezTo>
                  <a:pt x="30" y="467"/>
                  <a:pt x="0" y="437"/>
                  <a:pt x="0" y="400"/>
                </a:cubicBezTo>
                <a:cubicBezTo>
                  <a:pt x="0" y="364"/>
                  <a:pt x="30" y="334"/>
                  <a:pt x="66" y="334"/>
                </a:cubicBezTo>
                <a:close/>
                <a:moveTo>
                  <a:pt x="6833" y="0"/>
                </a:moveTo>
                <a:lnTo>
                  <a:pt x="7633" y="400"/>
                </a:lnTo>
                <a:lnTo>
                  <a:pt x="6833" y="800"/>
                </a:lnTo>
                <a:lnTo>
                  <a:pt x="6833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5" name="Freeform 9"/>
          <p:cNvSpPr>
            <a:spLocks/>
          </p:cNvSpPr>
          <p:nvPr/>
        </p:nvSpPr>
        <p:spPr bwMode="auto">
          <a:xfrm>
            <a:off x="2500535" y="2947988"/>
            <a:ext cx="1244965" cy="141288"/>
          </a:xfrm>
          <a:custGeom>
            <a:avLst/>
            <a:gdLst>
              <a:gd name="T0" fmla="*/ 784 w 10200"/>
              <a:gd name="T1" fmla="*/ 0 h 1133"/>
              <a:gd name="T2" fmla="*/ 719 w 10200"/>
              <a:gd name="T3" fmla="*/ 44 h 1133"/>
              <a:gd name="T4" fmla="*/ 457 w 10200"/>
              <a:gd name="T5" fmla="*/ 44 h 1133"/>
              <a:gd name="T6" fmla="*/ 392 w 10200"/>
              <a:gd name="T7" fmla="*/ 89 h 1133"/>
              <a:gd name="T8" fmla="*/ 327 w 10200"/>
              <a:gd name="T9" fmla="*/ 44 h 1133"/>
              <a:gd name="T10" fmla="*/ 65 w 10200"/>
              <a:gd name="T11" fmla="*/ 44 h 1133"/>
              <a:gd name="T12" fmla="*/ 0 w 10200"/>
              <a:gd name="T13" fmla="*/ 0 h 1133"/>
              <a:gd name="T14" fmla="*/ 0 60000 65536"/>
              <a:gd name="T15" fmla="*/ 0 60000 65536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w 10200"/>
              <a:gd name="T22" fmla="*/ 0 h 1133"/>
              <a:gd name="T23" fmla="*/ 10200 w 10200"/>
              <a:gd name="T24" fmla="*/ 1133 h 1133"/>
            </a:gdLst>
            <a:ahLst/>
            <a:cxnLst>
              <a:cxn ang="T14">
                <a:pos x="T0" y="T1"/>
              </a:cxn>
              <a:cxn ang="T15">
                <a:pos x="T2" y="T3"/>
              </a:cxn>
              <a:cxn ang="T16">
                <a:pos x="T4" y="T5"/>
              </a:cxn>
              <a:cxn ang="T17">
                <a:pos x="T6" y="T7"/>
              </a:cxn>
              <a:cxn ang="T18">
                <a:pos x="T8" y="T9"/>
              </a:cxn>
              <a:cxn ang="T19">
                <a:pos x="T10" y="T11"/>
              </a:cxn>
              <a:cxn ang="T20">
                <a:pos x="T12" y="T13"/>
              </a:cxn>
            </a:cxnLst>
            <a:rect l="T21" t="T22" r="T23" b="T24"/>
            <a:pathLst>
              <a:path w="10200" h="1133">
                <a:moveTo>
                  <a:pt x="10200" y="0"/>
                </a:moveTo>
                <a:cubicBezTo>
                  <a:pt x="10200" y="313"/>
                  <a:pt x="9819" y="566"/>
                  <a:pt x="9350" y="566"/>
                </a:cubicBezTo>
                <a:lnTo>
                  <a:pt x="5950" y="566"/>
                </a:lnTo>
                <a:cubicBezTo>
                  <a:pt x="5480" y="566"/>
                  <a:pt x="5100" y="820"/>
                  <a:pt x="5100" y="1133"/>
                </a:cubicBezTo>
                <a:cubicBezTo>
                  <a:pt x="5100" y="820"/>
                  <a:pt x="4719" y="566"/>
                  <a:pt x="4250" y="566"/>
                </a:cubicBezTo>
                <a:lnTo>
                  <a:pt x="850" y="566"/>
                </a:lnTo>
                <a:cubicBezTo>
                  <a:pt x="380" y="566"/>
                  <a:pt x="0" y="313"/>
                  <a:pt x="0" y="0"/>
                </a:cubicBezTo>
              </a:path>
            </a:pathLst>
          </a:custGeom>
          <a:noFill/>
          <a:ln w="4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6" name="Rectangle 11"/>
          <p:cNvSpPr>
            <a:spLocks noChangeArrowheads="1"/>
          </p:cNvSpPr>
          <p:nvPr/>
        </p:nvSpPr>
        <p:spPr bwMode="auto">
          <a:xfrm>
            <a:off x="3091258" y="3127376"/>
            <a:ext cx="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endParaRPr lang="en-US">
              <a:cs typeface="Arial" charset="0"/>
            </a:endParaRPr>
          </a:p>
        </p:txBody>
      </p:sp>
      <p:grpSp>
        <p:nvGrpSpPr>
          <p:cNvPr id="7" name="Group 15"/>
          <p:cNvGrpSpPr>
            <a:grpSpLocks/>
          </p:cNvGrpSpPr>
          <p:nvPr/>
        </p:nvGrpSpPr>
        <p:grpSpPr bwMode="auto">
          <a:xfrm>
            <a:off x="2454484" y="2806701"/>
            <a:ext cx="1337067" cy="47625"/>
            <a:chOff x="1516" y="1725"/>
            <a:chExt cx="842" cy="30"/>
          </a:xfrm>
        </p:grpSpPr>
        <p:sp>
          <p:nvSpPr>
            <p:cNvPr id="8" name="Rectangle 13"/>
            <p:cNvSpPr>
              <a:spLocks noChangeArrowheads="1"/>
            </p:cNvSpPr>
            <p:nvPr/>
          </p:nvSpPr>
          <p:spPr bwMode="auto">
            <a:xfrm>
              <a:off x="1516" y="1725"/>
              <a:ext cx="842" cy="3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  <p:sp>
          <p:nvSpPr>
            <p:cNvPr id="9" name="Rectangle 14"/>
            <p:cNvSpPr>
              <a:spLocks noChangeArrowheads="1"/>
            </p:cNvSpPr>
            <p:nvPr/>
          </p:nvSpPr>
          <p:spPr bwMode="auto">
            <a:xfrm>
              <a:off x="1516" y="1725"/>
              <a:ext cx="842" cy="30"/>
            </a:xfrm>
            <a:prstGeom prst="rect">
              <a:avLst/>
            </a:prstGeom>
            <a:noFill/>
            <a:ln w="4" cap="rnd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</p:grpSp>
      <p:sp>
        <p:nvSpPr>
          <p:cNvPr id="10" name="Rectangle 12"/>
          <p:cNvSpPr>
            <a:spLocks noChangeArrowheads="1"/>
          </p:cNvSpPr>
          <p:nvPr/>
        </p:nvSpPr>
        <p:spPr bwMode="auto">
          <a:xfrm>
            <a:off x="2929286" y="3130551"/>
            <a:ext cx="406519" cy="123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r>
              <a:rPr lang="nl-NL" sz="800">
                <a:solidFill>
                  <a:srgbClr val="000000"/>
                </a:solidFill>
                <a:cs typeface="Arial" charset="0"/>
              </a:rPr>
              <a:t>1000 bp</a:t>
            </a:r>
            <a:endParaRPr lang="nl-NL">
              <a:cs typeface="Arial" charset="0"/>
            </a:endParaRPr>
          </a:p>
        </p:txBody>
      </p:sp>
      <p:sp>
        <p:nvSpPr>
          <p:cNvPr id="11" name="Freeform 16"/>
          <p:cNvSpPr>
            <a:spLocks noEditPoints="1"/>
          </p:cNvSpPr>
          <p:nvPr/>
        </p:nvSpPr>
        <p:spPr bwMode="auto">
          <a:xfrm>
            <a:off x="4764974" y="2687638"/>
            <a:ext cx="466862" cy="50800"/>
          </a:xfrm>
          <a:custGeom>
            <a:avLst/>
            <a:gdLst>
              <a:gd name="T0" fmla="*/ 3 w 3817"/>
              <a:gd name="T1" fmla="*/ 13 h 400"/>
              <a:gd name="T2" fmla="*/ 268 w 3817"/>
              <a:gd name="T3" fmla="*/ 13 h 400"/>
              <a:gd name="T4" fmla="*/ 271 w 3817"/>
              <a:gd name="T5" fmla="*/ 16 h 400"/>
              <a:gd name="T6" fmla="*/ 268 w 3817"/>
              <a:gd name="T7" fmla="*/ 19 h 400"/>
              <a:gd name="T8" fmla="*/ 3 w 3817"/>
              <a:gd name="T9" fmla="*/ 19 h 400"/>
              <a:gd name="T10" fmla="*/ 0 w 3817"/>
              <a:gd name="T11" fmla="*/ 16 h 400"/>
              <a:gd name="T12" fmla="*/ 3 w 3817"/>
              <a:gd name="T13" fmla="*/ 13 h 400"/>
              <a:gd name="T14" fmla="*/ 263 w 3817"/>
              <a:gd name="T15" fmla="*/ 0 h 400"/>
              <a:gd name="T16" fmla="*/ 294 w 3817"/>
              <a:gd name="T17" fmla="*/ 16 h 400"/>
              <a:gd name="T18" fmla="*/ 263 w 3817"/>
              <a:gd name="T19" fmla="*/ 32 h 400"/>
              <a:gd name="T20" fmla="*/ 263 w 3817"/>
              <a:gd name="T21" fmla="*/ 0 h 4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3817"/>
              <a:gd name="T34" fmla="*/ 0 h 400"/>
              <a:gd name="T35" fmla="*/ 3817 w 3817"/>
              <a:gd name="T36" fmla="*/ 400 h 4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3817" h="400">
                <a:moveTo>
                  <a:pt x="33" y="167"/>
                </a:moveTo>
                <a:lnTo>
                  <a:pt x="3483" y="167"/>
                </a:lnTo>
                <a:cubicBezTo>
                  <a:pt x="3502" y="167"/>
                  <a:pt x="3517" y="182"/>
                  <a:pt x="3517" y="200"/>
                </a:cubicBezTo>
                <a:cubicBezTo>
                  <a:pt x="3517" y="219"/>
                  <a:pt x="3502" y="234"/>
                  <a:pt x="3483" y="234"/>
                </a:cubicBezTo>
                <a:lnTo>
                  <a:pt x="33" y="234"/>
                </a:lnTo>
                <a:cubicBezTo>
                  <a:pt x="15" y="234"/>
                  <a:pt x="0" y="219"/>
                  <a:pt x="0" y="200"/>
                </a:cubicBezTo>
                <a:cubicBezTo>
                  <a:pt x="0" y="182"/>
                  <a:pt x="15" y="167"/>
                  <a:pt x="33" y="167"/>
                </a:cubicBezTo>
                <a:close/>
                <a:moveTo>
                  <a:pt x="3417" y="0"/>
                </a:moveTo>
                <a:lnTo>
                  <a:pt x="3817" y="200"/>
                </a:lnTo>
                <a:lnTo>
                  <a:pt x="3417" y="400"/>
                </a:lnTo>
                <a:lnTo>
                  <a:pt x="3417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2" name="Freeform 17"/>
          <p:cNvSpPr>
            <a:spLocks noEditPoints="1"/>
          </p:cNvSpPr>
          <p:nvPr/>
        </p:nvSpPr>
        <p:spPr bwMode="auto">
          <a:xfrm>
            <a:off x="5711401" y="2687638"/>
            <a:ext cx="465274" cy="50800"/>
          </a:xfrm>
          <a:custGeom>
            <a:avLst/>
            <a:gdLst>
              <a:gd name="T0" fmla="*/ 290 w 1904"/>
              <a:gd name="T1" fmla="*/ 19 h 200"/>
              <a:gd name="T2" fmla="*/ 26 w 1904"/>
              <a:gd name="T3" fmla="*/ 19 h 200"/>
              <a:gd name="T4" fmla="*/ 23 w 1904"/>
              <a:gd name="T5" fmla="*/ 16 h 200"/>
              <a:gd name="T6" fmla="*/ 26 w 1904"/>
              <a:gd name="T7" fmla="*/ 13 h 200"/>
              <a:gd name="T8" fmla="*/ 290 w 1904"/>
              <a:gd name="T9" fmla="*/ 13 h 200"/>
              <a:gd name="T10" fmla="*/ 293 w 1904"/>
              <a:gd name="T11" fmla="*/ 16 h 200"/>
              <a:gd name="T12" fmla="*/ 290 w 1904"/>
              <a:gd name="T13" fmla="*/ 19 h 200"/>
              <a:gd name="T14" fmla="*/ 31 w 1904"/>
              <a:gd name="T15" fmla="*/ 32 h 200"/>
              <a:gd name="T16" fmla="*/ 0 w 1904"/>
              <a:gd name="T17" fmla="*/ 16 h 200"/>
              <a:gd name="T18" fmla="*/ 31 w 1904"/>
              <a:gd name="T19" fmla="*/ 0 h 200"/>
              <a:gd name="T20" fmla="*/ 31 w 1904"/>
              <a:gd name="T21" fmla="*/ 32 h 2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1904"/>
              <a:gd name="T34" fmla="*/ 0 h 200"/>
              <a:gd name="T35" fmla="*/ 1904 w 1904"/>
              <a:gd name="T36" fmla="*/ 200 h 2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1904" h="200">
                <a:moveTo>
                  <a:pt x="1887" y="117"/>
                </a:moveTo>
                <a:lnTo>
                  <a:pt x="166" y="117"/>
                </a:lnTo>
                <a:cubicBezTo>
                  <a:pt x="157" y="117"/>
                  <a:pt x="150" y="109"/>
                  <a:pt x="150" y="100"/>
                </a:cubicBezTo>
                <a:cubicBezTo>
                  <a:pt x="150" y="91"/>
                  <a:pt x="157" y="83"/>
                  <a:pt x="166" y="83"/>
                </a:cubicBezTo>
                <a:lnTo>
                  <a:pt x="1887" y="83"/>
                </a:lnTo>
                <a:cubicBezTo>
                  <a:pt x="1897" y="83"/>
                  <a:pt x="1904" y="91"/>
                  <a:pt x="1904" y="100"/>
                </a:cubicBezTo>
                <a:cubicBezTo>
                  <a:pt x="1904" y="109"/>
                  <a:pt x="1897" y="117"/>
                  <a:pt x="1887" y="117"/>
                </a:cubicBezTo>
                <a:close/>
                <a:moveTo>
                  <a:pt x="200" y="200"/>
                </a:moveTo>
                <a:lnTo>
                  <a:pt x="0" y="100"/>
                </a:lnTo>
                <a:lnTo>
                  <a:pt x="200" y="0"/>
                </a:lnTo>
                <a:lnTo>
                  <a:pt x="200" y="20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US"/>
          </a:p>
        </p:txBody>
      </p:sp>
      <p:grpSp>
        <p:nvGrpSpPr>
          <p:cNvPr id="13" name="Group 20"/>
          <p:cNvGrpSpPr>
            <a:grpSpLocks/>
          </p:cNvGrpSpPr>
          <p:nvPr/>
        </p:nvGrpSpPr>
        <p:grpSpPr bwMode="auto">
          <a:xfrm>
            <a:off x="4788793" y="2806701"/>
            <a:ext cx="1338655" cy="47625"/>
            <a:chOff x="2986" y="1725"/>
            <a:chExt cx="843" cy="30"/>
          </a:xfrm>
        </p:grpSpPr>
        <p:sp>
          <p:nvSpPr>
            <p:cNvPr id="14" name="Rectangle 18"/>
            <p:cNvSpPr>
              <a:spLocks noChangeArrowheads="1"/>
            </p:cNvSpPr>
            <p:nvPr/>
          </p:nvSpPr>
          <p:spPr bwMode="auto">
            <a:xfrm>
              <a:off x="2986" y="1725"/>
              <a:ext cx="843" cy="3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  <p:sp>
          <p:nvSpPr>
            <p:cNvPr id="15" name="Rectangle 19"/>
            <p:cNvSpPr>
              <a:spLocks noChangeArrowheads="1"/>
            </p:cNvSpPr>
            <p:nvPr/>
          </p:nvSpPr>
          <p:spPr bwMode="auto">
            <a:xfrm>
              <a:off x="2986" y="1725"/>
              <a:ext cx="843" cy="30"/>
            </a:xfrm>
            <a:prstGeom prst="rect">
              <a:avLst/>
            </a:prstGeom>
            <a:noFill/>
            <a:ln w="4" cap="rnd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</p:grpSp>
      <p:sp>
        <p:nvSpPr>
          <p:cNvPr id="16" name="Freeform 21"/>
          <p:cNvSpPr>
            <a:spLocks/>
          </p:cNvSpPr>
          <p:nvPr/>
        </p:nvSpPr>
        <p:spPr bwMode="auto">
          <a:xfrm>
            <a:off x="4853900" y="2947988"/>
            <a:ext cx="1244965" cy="141288"/>
          </a:xfrm>
          <a:custGeom>
            <a:avLst/>
            <a:gdLst>
              <a:gd name="T0" fmla="*/ 784 w 5100"/>
              <a:gd name="T1" fmla="*/ 0 h 566"/>
              <a:gd name="T2" fmla="*/ 719 w 5100"/>
              <a:gd name="T3" fmla="*/ 45 h 566"/>
              <a:gd name="T4" fmla="*/ 457 w 5100"/>
              <a:gd name="T5" fmla="*/ 45 h 566"/>
              <a:gd name="T6" fmla="*/ 392 w 5100"/>
              <a:gd name="T7" fmla="*/ 89 h 566"/>
              <a:gd name="T8" fmla="*/ 327 w 5100"/>
              <a:gd name="T9" fmla="*/ 45 h 566"/>
              <a:gd name="T10" fmla="*/ 65 w 5100"/>
              <a:gd name="T11" fmla="*/ 45 h 566"/>
              <a:gd name="T12" fmla="*/ 0 w 5100"/>
              <a:gd name="T13" fmla="*/ 0 h 566"/>
              <a:gd name="T14" fmla="*/ 0 60000 65536"/>
              <a:gd name="T15" fmla="*/ 0 60000 65536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w 5100"/>
              <a:gd name="T22" fmla="*/ 0 h 566"/>
              <a:gd name="T23" fmla="*/ 5100 w 5100"/>
              <a:gd name="T24" fmla="*/ 566 h 566"/>
            </a:gdLst>
            <a:ahLst/>
            <a:cxnLst>
              <a:cxn ang="T14">
                <a:pos x="T0" y="T1"/>
              </a:cxn>
              <a:cxn ang="T15">
                <a:pos x="T2" y="T3"/>
              </a:cxn>
              <a:cxn ang="T16">
                <a:pos x="T4" y="T5"/>
              </a:cxn>
              <a:cxn ang="T17">
                <a:pos x="T6" y="T7"/>
              </a:cxn>
              <a:cxn ang="T18">
                <a:pos x="T8" y="T9"/>
              </a:cxn>
              <a:cxn ang="T19">
                <a:pos x="T10" y="T11"/>
              </a:cxn>
              <a:cxn ang="T20">
                <a:pos x="T12" y="T13"/>
              </a:cxn>
            </a:cxnLst>
            <a:rect l="T21" t="T22" r="T23" b="T24"/>
            <a:pathLst>
              <a:path w="5100" h="566">
                <a:moveTo>
                  <a:pt x="5100" y="0"/>
                </a:moveTo>
                <a:cubicBezTo>
                  <a:pt x="5100" y="156"/>
                  <a:pt x="4910" y="283"/>
                  <a:pt x="4675" y="283"/>
                </a:cubicBezTo>
                <a:lnTo>
                  <a:pt x="2975" y="283"/>
                </a:lnTo>
                <a:cubicBezTo>
                  <a:pt x="2741" y="283"/>
                  <a:pt x="2550" y="410"/>
                  <a:pt x="2550" y="566"/>
                </a:cubicBezTo>
                <a:cubicBezTo>
                  <a:pt x="2550" y="410"/>
                  <a:pt x="2360" y="283"/>
                  <a:pt x="2125" y="283"/>
                </a:cubicBezTo>
                <a:lnTo>
                  <a:pt x="425" y="283"/>
                </a:lnTo>
                <a:cubicBezTo>
                  <a:pt x="191" y="283"/>
                  <a:pt x="0" y="156"/>
                  <a:pt x="0" y="0"/>
                </a:cubicBezTo>
              </a:path>
            </a:pathLst>
          </a:custGeom>
          <a:noFill/>
          <a:ln w="4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7" name="Rectangle 26"/>
          <p:cNvSpPr>
            <a:spLocks noChangeArrowheads="1"/>
          </p:cNvSpPr>
          <p:nvPr/>
        </p:nvSpPr>
        <p:spPr bwMode="auto">
          <a:xfrm>
            <a:off x="3432671" y="2536826"/>
            <a:ext cx="366820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1200" b="1" dirty="0" smtClean="0">
                <a:solidFill>
                  <a:srgbClr val="0000FF"/>
                </a:solidFill>
                <a:cs typeface="Arial" charset="0"/>
              </a:rPr>
              <a:t>P2T1</a:t>
            </a:r>
            <a:endParaRPr lang="nl-NL" dirty="0">
              <a:cs typeface="Arial" charset="0"/>
            </a:endParaRPr>
          </a:p>
        </p:txBody>
      </p:sp>
      <p:sp>
        <p:nvSpPr>
          <p:cNvPr id="18" name="Rectangle 27"/>
          <p:cNvSpPr>
            <a:spLocks noChangeArrowheads="1"/>
          </p:cNvSpPr>
          <p:nvPr/>
        </p:nvSpPr>
        <p:spPr bwMode="auto">
          <a:xfrm>
            <a:off x="4903127" y="2563813"/>
            <a:ext cx="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endParaRPr lang="en-US">
              <a:cs typeface="Arial" charset="0"/>
            </a:endParaRPr>
          </a:p>
        </p:txBody>
      </p:sp>
      <p:sp>
        <p:nvSpPr>
          <p:cNvPr id="19" name="Rectangle 28"/>
          <p:cNvSpPr>
            <a:spLocks noChangeArrowheads="1"/>
          </p:cNvSpPr>
          <p:nvPr/>
        </p:nvSpPr>
        <p:spPr bwMode="auto">
          <a:xfrm>
            <a:off x="5809855" y="2536826"/>
            <a:ext cx="366820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1200" b="1" dirty="0" smtClean="0">
                <a:solidFill>
                  <a:srgbClr val="0000FF"/>
                </a:solidFill>
                <a:cs typeface="Arial" charset="0"/>
              </a:rPr>
              <a:t>P4T1</a:t>
            </a:r>
            <a:endParaRPr lang="nl-NL" dirty="0">
              <a:cs typeface="Arial" charset="0"/>
            </a:endParaRPr>
          </a:p>
        </p:txBody>
      </p:sp>
      <p:sp>
        <p:nvSpPr>
          <p:cNvPr id="20" name="Line 29"/>
          <p:cNvSpPr>
            <a:spLocks noChangeShapeType="1"/>
          </p:cNvSpPr>
          <p:nvPr/>
        </p:nvSpPr>
        <p:spPr bwMode="auto">
          <a:xfrm flipH="1" flipV="1">
            <a:off x="2222641" y="2617788"/>
            <a:ext cx="184204" cy="95250"/>
          </a:xfrm>
          <a:prstGeom prst="line">
            <a:avLst/>
          </a:prstGeom>
          <a:noFill/>
          <a:ln w="4" cap="rnd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1" name="Line 30"/>
          <p:cNvSpPr>
            <a:spLocks noChangeShapeType="1"/>
          </p:cNvSpPr>
          <p:nvPr/>
        </p:nvSpPr>
        <p:spPr bwMode="auto">
          <a:xfrm flipV="1">
            <a:off x="3791551" y="2617788"/>
            <a:ext cx="185792" cy="95250"/>
          </a:xfrm>
          <a:prstGeom prst="line">
            <a:avLst/>
          </a:prstGeom>
          <a:noFill/>
          <a:ln w="4" cap="rnd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2" name="Line 31"/>
          <p:cNvSpPr>
            <a:spLocks noChangeShapeType="1"/>
          </p:cNvSpPr>
          <p:nvPr/>
        </p:nvSpPr>
        <p:spPr bwMode="auto">
          <a:xfrm flipH="1" flipV="1">
            <a:off x="4576006" y="2617788"/>
            <a:ext cx="184204" cy="95250"/>
          </a:xfrm>
          <a:prstGeom prst="line">
            <a:avLst/>
          </a:prstGeom>
          <a:noFill/>
          <a:ln w="4" cap="rnd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3" name="Line 32"/>
          <p:cNvSpPr>
            <a:spLocks noChangeShapeType="1"/>
          </p:cNvSpPr>
          <p:nvPr/>
        </p:nvSpPr>
        <p:spPr bwMode="auto">
          <a:xfrm flipV="1">
            <a:off x="6181439" y="2619376"/>
            <a:ext cx="184204" cy="93663"/>
          </a:xfrm>
          <a:prstGeom prst="line">
            <a:avLst/>
          </a:prstGeom>
          <a:noFill/>
          <a:ln w="4" cap="rnd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4" name="Freeform 33"/>
          <p:cNvSpPr>
            <a:spLocks noEditPoints="1"/>
          </p:cNvSpPr>
          <p:nvPr/>
        </p:nvSpPr>
        <p:spPr bwMode="auto">
          <a:xfrm>
            <a:off x="3331041" y="2687638"/>
            <a:ext cx="465274" cy="50800"/>
          </a:xfrm>
          <a:custGeom>
            <a:avLst/>
            <a:gdLst>
              <a:gd name="T0" fmla="*/ 290 w 3808"/>
              <a:gd name="T1" fmla="*/ 19 h 400"/>
              <a:gd name="T2" fmla="*/ 26 w 3808"/>
              <a:gd name="T3" fmla="*/ 19 h 400"/>
              <a:gd name="T4" fmla="*/ 23 w 3808"/>
              <a:gd name="T5" fmla="*/ 16 h 400"/>
              <a:gd name="T6" fmla="*/ 26 w 3808"/>
              <a:gd name="T7" fmla="*/ 13 h 400"/>
              <a:gd name="T8" fmla="*/ 290 w 3808"/>
              <a:gd name="T9" fmla="*/ 13 h 400"/>
              <a:gd name="T10" fmla="*/ 293 w 3808"/>
              <a:gd name="T11" fmla="*/ 16 h 400"/>
              <a:gd name="T12" fmla="*/ 290 w 3808"/>
              <a:gd name="T13" fmla="*/ 19 h 400"/>
              <a:gd name="T14" fmla="*/ 31 w 3808"/>
              <a:gd name="T15" fmla="*/ 32 h 400"/>
              <a:gd name="T16" fmla="*/ 0 w 3808"/>
              <a:gd name="T17" fmla="*/ 16 h 400"/>
              <a:gd name="T18" fmla="*/ 31 w 3808"/>
              <a:gd name="T19" fmla="*/ 0 h 400"/>
              <a:gd name="T20" fmla="*/ 31 w 3808"/>
              <a:gd name="T21" fmla="*/ 32 h 4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3808"/>
              <a:gd name="T34" fmla="*/ 0 h 400"/>
              <a:gd name="T35" fmla="*/ 3808 w 3808"/>
              <a:gd name="T36" fmla="*/ 400 h 4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3808" h="400">
                <a:moveTo>
                  <a:pt x="3775" y="234"/>
                </a:moveTo>
                <a:lnTo>
                  <a:pt x="333" y="234"/>
                </a:lnTo>
                <a:cubicBezTo>
                  <a:pt x="315" y="234"/>
                  <a:pt x="300" y="219"/>
                  <a:pt x="300" y="200"/>
                </a:cubicBezTo>
                <a:cubicBezTo>
                  <a:pt x="300" y="182"/>
                  <a:pt x="315" y="167"/>
                  <a:pt x="333" y="167"/>
                </a:cubicBezTo>
                <a:lnTo>
                  <a:pt x="3775" y="167"/>
                </a:lnTo>
                <a:cubicBezTo>
                  <a:pt x="3794" y="167"/>
                  <a:pt x="3808" y="182"/>
                  <a:pt x="3808" y="200"/>
                </a:cubicBezTo>
                <a:cubicBezTo>
                  <a:pt x="3808" y="219"/>
                  <a:pt x="3794" y="234"/>
                  <a:pt x="3775" y="234"/>
                </a:cubicBezTo>
                <a:close/>
                <a:moveTo>
                  <a:pt x="400" y="400"/>
                </a:moveTo>
                <a:lnTo>
                  <a:pt x="0" y="200"/>
                </a:lnTo>
                <a:lnTo>
                  <a:pt x="400" y="0"/>
                </a:lnTo>
                <a:lnTo>
                  <a:pt x="400" y="40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5" name="Freeform 34"/>
          <p:cNvSpPr>
            <a:spLocks noEditPoints="1"/>
          </p:cNvSpPr>
          <p:nvPr/>
        </p:nvSpPr>
        <p:spPr bwMode="auto">
          <a:xfrm>
            <a:off x="2403669" y="2687638"/>
            <a:ext cx="465274" cy="50800"/>
          </a:xfrm>
          <a:custGeom>
            <a:avLst/>
            <a:gdLst>
              <a:gd name="T0" fmla="*/ 3 w 7633"/>
              <a:gd name="T1" fmla="*/ 13 h 800"/>
              <a:gd name="T2" fmla="*/ 267 w 7633"/>
              <a:gd name="T3" fmla="*/ 13 h 800"/>
              <a:gd name="T4" fmla="*/ 270 w 7633"/>
              <a:gd name="T5" fmla="*/ 16 h 800"/>
              <a:gd name="T6" fmla="*/ 267 w 7633"/>
              <a:gd name="T7" fmla="*/ 19 h 800"/>
              <a:gd name="T8" fmla="*/ 3 w 7633"/>
              <a:gd name="T9" fmla="*/ 19 h 800"/>
              <a:gd name="T10" fmla="*/ 0 w 7633"/>
              <a:gd name="T11" fmla="*/ 16 h 800"/>
              <a:gd name="T12" fmla="*/ 3 w 7633"/>
              <a:gd name="T13" fmla="*/ 13 h 800"/>
              <a:gd name="T14" fmla="*/ 262 w 7633"/>
              <a:gd name="T15" fmla="*/ 0 h 800"/>
              <a:gd name="T16" fmla="*/ 293 w 7633"/>
              <a:gd name="T17" fmla="*/ 16 h 800"/>
              <a:gd name="T18" fmla="*/ 262 w 7633"/>
              <a:gd name="T19" fmla="*/ 32 h 800"/>
              <a:gd name="T20" fmla="*/ 262 w 7633"/>
              <a:gd name="T21" fmla="*/ 0 h 8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7633"/>
              <a:gd name="T34" fmla="*/ 0 h 800"/>
              <a:gd name="T35" fmla="*/ 7633 w 7633"/>
              <a:gd name="T36" fmla="*/ 800 h 8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7633" h="800">
                <a:moveTo>
                  <a:pt x="66" y="334"/>
                </a:moveTo>
                <a:lnTo>
                  <a:pt x="6966" y="334"/>
                </a:lnTo>
                <a:cubicBezTo>
                  <a:pt x="7003" y="334"/>
                  <a:pt x="7033" y="364"/>
                  <a:pt x="7033" y="400"/>
                </a:cubicBezTo>
                <a:cubicBezTo>
                  <a:pt x="7033" y="437"/>
                  <a:pt x="7003" y="467"/>
                  <a:pt x="6966" y="467"/>
                </a:cubicBezTo>
                <a:lnTo>
                  <a:pt x="66" y="467"/>
                </a:lnTo>
                <a:cubicBezTo>
                  <a:pt x="30" y="467"/>
                  <a:pt x="0" y="437"/>
                  <a:pt x="0" y="400"/>
                </a:cubicBezTo>
                <a:cubicBezTo>
                  <a:pt x="0" y="364"/>
                  <a:pt x="30" y="334"/>
                  <a:pt x="66" y="334"/>
                </a:cubicBezTo>
                <a:close/>
                <a:moveTo>
                  <a:pt x="6833" y="0"/>
                </a:moveTo>
                <a:lnTo>
                  <a:pt x="7633" y="400"/>
                </a:lnTo>
                <a:lnTo>
                  <a:pt x="6833" y="800"/>
                </a:lnTo>
                <a:lnTo>
                  <a:pt x="6833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6" name="Freeform 35"/>
          <p:cNvSpPr>
            <a:spLocks/>
          </p:cNvSpPr>
          <p:nvPr/>
        </p:nvSpPr>
        <p:spPr bwMode="auto">
          <a:xfrm>
            <a:off x="2500535" y="2947988"/>
            <a:ext cx="1244965" cy="141288"/>
          </a:xfrm>
          <a:custGeom>
            <a:avLst/>
            <a:gdLst>
              <a:gd name="T0" fmla="*/ 784 w 10200"/>
              <a:gd name="T1" fmla="*/ 0 h 1133"/>
              <a:gd name="T2" fmla="*/ 719 w 10200"/>
              <a:gd name="T3" fmla="*/ 44 h 1133"/>
              <a:gd name="T4" fmla="*/ 457 w 10200"/>
              <a:gd name="T5" fmla="*/ 44 h 1133"/>
              <a:gd name="T6" fmla="*/ 392 w 10200"/>
              <a:gd name="T7" fmla="*/ 89 h 1133"/>
              <a:gd name="T8" fmla="*/ 327 w 10200"/>
              <a:gd name="T9" fmla="*/ 44 h 1133"/>
              <a:gd name="T10" fmla="*/ 65 w 10200"/>
              <a:gd name="T11" fmla="*/ 44 h 1133"/>
              <a:gd name="T12" fmla="*/ 0 w 10200"/>
              <a:gd name="T13" fmla="*/ 0 h 1133"/>
              <a:gd name="T14" fmla="*/ 0 60000 65536"/>
              <a:gd name="T15" fmla="*/ 0 60000 65536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w 10200"/>
              <a:gd name="T22" fmla="*/ 0 h 1133"/>
              <a:gd name="T23" fmla="*/ 10200 w 10200"/>
              <a:gd name="T24" fmla="*/ 1133 h 1133"/>
            </a:gdLst>
            <a:ahLst/>
            <a:cxnLst>
              <a:cxn ang="T14">
                <a:pos x="T0" y="T1"/>
              </a:cxn>
              <a:cxn ang="T15">
                <a:pos x="T2" y="T3"/>
              </a:cxn>
              <a:cxn ang="T16">
                <a:pos x="T4" y="T5"/>
              </a:cxn>
              <a:cxn ang="T17">
                <a:pos x="T6" y="T7"/>
              </a:cxn>
              <a:cxn ang="T18">
                <a:pos x="T8" y="T9"/>
              </a:cxn>
              <a:cxn ang="T19">
                <a:pos x="T10" y="T11"/>
              </a:cxn>
              <a:cxn ang="T20">
                <a:pos x="T12" y="T13"/>
              </a:cxn>
            </a:cxnLst>
            <a:rect l="T21" t="T22" r="T23" b="T24"/>
            <a:pathLst>
              <a:path w="10200" h="1133">
                <a:moveTo>
                  <a:pt x="10200" y="0"/>
                </a:moveTo>
                <a:cubicBezTo>
                  <a:pt x="10200" y="313"/>
                  <a:pt x="9819" y="566"/>
                  <a:pt x="9350" y="566"/>
                </a:cubicBezTo>
                <a:lnTo>
                  <a:pt x="5950" y="566"/>
                </a:lnTo>
                <a:cubicBezTo>
                  <a:pt x="5480" y="566"/>
                  <a:pt x="5100" y="820"/>
                  <a:pt x="5100" y="1133"/>
                </a:cubicBezTo>
                <a:cubicBezTo>
                  <a:pt x="5100" y="820"/>
                  <a:pt x="4719" y="566"/>
                  <a:pt x="4250" y="566"/>
                </a:cubicBezTo>
                <a:lnTo>
                  <a:pt x="850" y="566"/>
                </a:lnTo>
                <a:cubicBezTo>
                  <a:pt x="380" y="566"/>
                  <a:pt x="0" y="313"/>
                  <a:pt x="0" y="0"/>
                </a:cubicBezTo>
              </a:path>
            </a:pathLst>
          </a:custGeom>
          <a:noFill/>
          <a:ln w="4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7" name="Rectangle 36"/>
          <p:cNvSpPr>
            <a:spLocks noChangeArrowheads="1"/>
          </p:cNvSpPr>
          <p:nvPr/>
        </p:nvSpPr>
        <p:spPr bwMode="auto">
          <a:xfrm>
            <a:off x="2929286" y="3127376"/>
            <a:ext cx="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endParaRPr lang="en-US">
              <a:cs typeface="Arial" charset="0"/>
            </a:endParaRPr>
          </a:p>
        </p:txBody>
      </p:sp>
      <p:grpSp>
        <p:nvGrpSpPr>
          <p:cNvPr id="28" name="Group 41"/>
          <p:cNvGrpSpPr>
            <a:grpSpLocks/>
          </p:cNvGrpSpPr>
          <p:nvPr/>
        </p:nvGrpSpPr>
        <p:grpSpPr bwMode="auto">
          <a:xfrm>
            <a:off x="2454484" y="2806701"/>
            <a:ext cx="1337067" cy="47625"/>
            <a:chOff x="1516" y="1725"/>
            <a:chExt cx="842" cy="30"/>
          </a:xfrm>
        </p:grpSpPr>
        <p:sp>
          <p:nvSpPr>
            <p:cNvPr id="29" name="Rectangle 39"/>
            <p:cNvSpPr>
              <a:spLocks noChangeArrowheads="1"/>
            </p:cNvSpPr>
            <p:nvPr/>
          </p:nvSpPr>
          <p:spPr bwMode="auto">
            <a:xfrm>
              <a:off x="1516" y="1725"/>
              <a:ext cx="842" cy="3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  <p:sp>
          <p:nvSpPr>
            <p:cNvPr id="30" name="Rectangle 40"/>
            <p:cNvSpPr>
              <a:spLocks noChangeArrowheads="1"/>
            </p:cNvSpPr>
            <p:nvPr/>
          </p:nvSpPr>
          <p:spPr bwMode="auto">
            <a:xfrm>
              <a:off x="1516" y="1725"/>
              <a:ext cx="842" cy="30"/>
            </a:xfrm>
            <a:prstGeom prst="rect">
              <a:avLst/>
            </a:prstGeom>
            <a:noFill/>
            <a:ln w="4" cap="rnd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</p:grpSp>
      <p:sp>
        <p:nvSpPr>
          <p:cNvPr id="31" name="Freeform 42"/>
          <p:cNvSpPr>
            <a:spLocks noEditPoints="1"/>
          </p:cNvSpPr>
          <p:nvPr/>
        </p:nvSpPr>
        <p:spPr bwMode="auto">
          <a:xfrm>
            <a:off x="4764974" y="2687638"/>
            <a:ext cx="466862" cy="50800"/>
          </a:xfrm>
          <a:custGeom>
            <a:avLst/>
            <a:gdLst>
              <a:gd name="T0" fmla="*/ 3 w 3817"/>
              <a:gd name="T1" fmla="*/ 13 h 400"/>
              <a:gd name="T2" fmla="*/ 268 w 3817"/>
              <a:gd name="T3" fmla="*/ 13 h 400"/>
              <a:gd name="T4" fmla="*/ 271 w 3817"/>
              <a:gd name="T5" fmla="*/ 16 h 400"/>
              <a:gd name="T6" fmla="*/ 268 w 3817"/>
              <a:gd name="T7" fmla="*/ 19 h 400"/>
              <a:gd name="T8" fmla="*/ 3 w 3817"/>
              <a:gd name="T9" fmla="*/ 19 h 400"/>
              <a:gd name="T10" fmla="*/ 0 w 3817"/>
              <a:gd name="T11" fmla="*/ 16 h 400"/>
              <a:gd name="T12" fmla="*/ 3 w 3817"/>
              <a:gd name="T13" fmla="*/ 13 h 400"/>
              <a:gd name="T14" fmla="*/ 263 w 3817"/>
              <a:gd name="T15" fmla="*/ 0 h 400"/>
              <a:gd name="T16" fmla="*/ 294 w 3817"/>
              <a:gd name="T17" fmla="*/ 16 h 400"/>
              <a:gd name="T18" fmla="*/ 263 w 3817"/>
              <a:gd name="T19" fmla="*/ 32 h 400"/>
              <a:gd name="T20" fmla="*/ 263 w 3817"/>
              <a:gd name="T21" fmla="*/ 0 h 4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3817"/>
              <a:gd name="T34" fmla="*/ 0 h 400"/>
              <a:gd name="T35" fmla="*/ 3817 w 3817"/>
              <a:gd name="T36" fmla="*/ 400 h 4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3817" h="400">
                <a:moveTo>
                  <a:pt x="33" y="167"/>
                </a:moveTo>
                <a:lnTo>
                  <a:pt x="3483" y="167"/>
                </a:lnTo>
                <a:cubicBezTo>
                  <a:pt x="3502" y="167"/>
                  <a:pt x="3517" y="182"/>
                  <a:pt x="3517" y="200"/>
                </a:cubicBezTo>
                <a:cubicBezTo>
                  <a:pt x="3517" y="219"/>
                  <a:pt x="3502" y="234"/>
                  <a:pt x="3483" y="234"/>
                </a:cubicBezTo>
                <a:lnTo>
                  <a:pt x="33" y="234"/>
                </a:lnTo>
                <a:cubicBezTo>
                  <a:pt x="15" y="234"/>
                  <a:pt x="0" y="219"/>
                  <a:pt x="0" y="200"/>
                </a:cubicBezTo>
                <a:cubicBezTo>
                  <a:pt x="0" y="182"/>
                  <a:pt x="15" y="167"/>
                  <a:pt x="33" y="167"/>
                </a:cubicBezTo>
                <a:close/>
                <a:moveTo>
                  <a:pt x="3417" y="0"/>
                </a:moveTo>
                <a:lnTo>
                  <a:pt x="3817" y="200"/>
                </a:lnTo>
                <a:lnTo>
                  <a:pt x="3417" y="400"/>
                </a:lnTo>
                <a:lnTo>
                  <a:pt x="3417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32" name="Freeform 43"/>
          <p:cNvSpPr>
            <a:spLocks noEditPoints="1"/>
          </p:cNvSpPr>
          <p:nvPr/>
        </p:nvSpPr>
        <p:spPr bwMode="auto">
          <a:xfrm>
            <a:off x="5711401" y="2687638"/>
            <a:ext cx="465274" cy="50800"/>
          </a:xfrm>
          <a:custGeom>
            <a:avLst/>
            <a:gdLst>
              <a:gd name="T0" fmla="*/ 290 w 1904"/>
              <a:gd name="T1" fmla="*/ 19 h 200"/>
              <a:gd name="T2" fmla="*/ 26 w 1904"/>
              <a:gd name="T3" fmla="*/ 19 h 200"/>
              <a:gd name="T4" fmla="*/ 23 w 1904"/>
              <a:gd name="T5" fmla="*/ 16 h 200"/>
              <a:gd name="T6" fmla="*/ 26 w 1904"/>
              <a:gd name="T7" fmla="*/ 13 h 200"/>
              <a:gd name="T8" fmla="*/ 290 w 1904"/>
              <a:gd name="T9" fmla="*/ 13 h 200"/>
              <a:gd name="T10" fmla="*/ 293 w 1904"/>
              <a:gd name="T11" fmla="*/ 16 h 200"/>
              <a:gd name="T12" fmla="*/ 290 w 1904"/>
              <a:gd name="T13" fmla="*/ 19 h 200"/>
              <a:gd name="T14" fmla="*/ 31 w 1904"/>
              <a:gd name="T15" fmla="*/ 32 h 200"/>
              <a:gd name="T16" fmla="*/ 0 w 1904"/>
              <a:gd name="T17" fmla="*/ 16 h 200"/>
              <a:gd name="T18" fmla="*/ 31 w 1904"/>
              <a:gd name="T19" fmla="*/ 0 h 200"/>
              <a:gd name="T20" fmla="*/ 31 w 1904"/>
              <a:gd name="T21" fmla="*/ 32 h 2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1904"/>
              <a:gd name="T34" fmla="*/ 0 h 200"/>
              <a:gd name="T35" fmla="*/ 1904 w 1904"/>
              <a:gd name="T36" fmla="*/ 200 h 2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1904" h="200">
                <a:moveTo>
                  <a:pt x="1887" y="117"/>
                </a:moveTo>
                <a:lnTo>
                  <a:pt x="166" y="117"/>
                </a:lnTo>
                <a:cubicBezTo>
                  <a:pt x="157" y="117"/>
                  <a:pt x="150" y="109"/>
                  <a:pt x="150" y="100"/>
                </a:cubicBezTo>
                <a:cubicBezTo>
                  <a:pt x="150" y="91"/>
                  <a:pt x="157" y="83"/>
                  <a:pt x="166" y="83"/>
                </a:cubicBezTo>
                <a:lnTo>
                  <a:pt x="1887" y="83"/>
                </a:lnTo>
                <a:cubicBezTo>
                  <a:pt x="1897" y="83"/>
                  <a:pt x="1904" y="91"/>
                  <a:pt x="1904" y="100"/>
                </a:cubicBezTo>
                <a:cubicBezTo>
                  <a:pt x="1904" y="109"/>
                  <a:pt x="1897" y="117"/>
                  <a:pt x="1887" y="117"/>
                </a:cubicBezTo>
                <a:close/>
                <a:moveTo>
                  <a:pt x="200" y="200"/>
                </a:moveTo>
                <a:lnTo>
                  <a:pt x="0" y="100"/>
                </a:lnTo>
                <a:lnTo>
                  <a:pt x="200" y="0"/>
                </a:lnTo>
                <a:lnTo>
                  <a:pt x="200" y="20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US"/>
          </a:p>
        </p:txBody>
      </p:sp>
      <p:grpSp>
        <p:nvGrpSpPr>
          <p:cNvPr id="33" name="Group 46"/>
          <p:cNvGrpSpPr>
            <a:grpSpLocks/>
          </p:cNvGrpSpPr>
          <p:nvPr/>
        </p:nvGrpSpPr>
        <p:grpSpPr bwMode="auto">
          <a:xfrm>
            <a:off x="4788793" y="2806701"/>
            <a:ext cx="1338655" cy="47625"/>
            <a:chOff x="2986" y="1725"/>
            <a:chExt cx="843" cy="30"/>
          </a:xfrm>
        </p:grpSpPr>
        <p:sp>
          <p:nvSpPr>
            <p:cNvPr id="34" name="Rectangle 44"/>
            <p:cNvSpPr>
              <a:spLocks noChangeArrowheads="1"/>
            </p:cNvSpPr>
            <p:nvPr/>
          </p:nvSpPr>
          <p:spPr bwMode="auto">
            <a:xfrm>
              <a:off x="2986" y="1725"/>
              <a:ext cx="843" cy="3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  <p:sp>
          <p:nvSpPr>
            <p:cNvPr id="35" name="Rectangle 45"/>
            <p:cNvSpPr>
              <a:spLocks noChangeArrowheads="1"/>
            </p:cNvSpPr>
            <p:nvPr/>
          </p:nvSpPr>
          <p:spPr bwMode="auto">
            <a:xfrm>
              <a:off x="2986" y="1725"/>
              <a:ext cx="843" cy="30"/>
            </a:xfrm>
            <a:prstGeom prst="rect">
              <a:avLst/>
            </a:prstGeom>
            <a:noFill/>
            <a:ln w="4" cap="rnd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</p:grpSp>
      <p:sp>
        <p:nvSpPr>
          <p:cNvPr id="36" name="Freeform 47"/>
          <p:cNvSpPr>
            <a:spLocks/>
          </p:cNvSpPr>
          <p:nvPr/>
        </p:nvSpPr>
        <p:spPr bwMode="auto">
          <a:xfrm>
            <a:off x="4853900" y="2947988"/>
            <a:ext cx="1244965" cy="141288"/>
          </a:xfrm>
          <a:custGeom>
            <a:avLst/>
            <a:gdLst>
              <a:gd name="T0" fmla="*/ 784 w 5100"/>
              <a:gd name="T1" fmla="*/ 0 h 566"/>
              <a:gd name="T2" fmla="*/ 719 w 5100"/>
              <a:gd name="T3" fmla="*/ 45 h 566"/>
              <a:gd name="T4" fmla="*/ 457 w 5100"/>
              <a:gd name="T5" fmla="*/ 45 h 566"/>
              <a:gd name="T6" fmla="*/ 392 w 5100"/>
              <a:gd name="T7" fmla="*/ 89 h 566"/>
              <a:gd name="T8" fmla="*/ 327 w 5100"/>
              <a:gd name="T9" fmla="*/ 45 h 566"/>
              <a:gd name="T10" fmla="*/ 65 w 5100"/>
              <a:gd name="T11" fmla="*/ 45 h 566"/>
              <a:gd name="T12" fmla="*/ 0 w 5100"/>
              <a:gd name="T13" fmla="*/ 0 h 566"/>
              <a:gd name="T14" fmla="*/ 0 60000 65536"/>
              <a:gd name="T15" fmla="*/ 0 60000 65536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w 5100"/>
              <a:gd name="T22" fmla="*/ 0 h 566"/>
              <a:gd name="T23" fmla="*/ 5100 w 5100"/>
              <a:gd name="T24" fmla="*/ 566 h 566"/>
            </a:gdLst>
            <a:ahLst/>
            <a:cxnLst>
              <a:cxn ang="T14">
                <a:pos x="T0" y="T1"/>
              </a:cxn>
              <a:cxn ang="T15">
                <a:pos x="T2" y="T3"/>
              </a:cxn>
              <a:cxn ang="T16">
                <a:pos x="T4" y="T5"/>
              </a:cxn>
              <a:cxn ang="T17">
                <a:pos x="T6" y="T7"/>
              </a:cxn>
              <a:cxn ang="T18">
                <a:pos x="T8" y="T9"/>
              </a:cxn>
              <a:cxn ang="T19">
                <a:pos x="T10" y="T11"/>
              </a:cxn>
              <a:cxn ang="T20">
                <a:pos x="T12" y="T13"/>
              </a:cxn>
            </a:cxnLst>
            <a:rect l="T21" t="T22" r="T23" b="T24"/>
            <a:pathLst>
              <a:path w="5100" h="566">
                <a:moveTo>
                  <a:pt x="5100" y="0"/>
                </a:moveTo>
                <a:cubicBezTo>
                  <a:pt x="5100" y="156"/>
                  <a:pt x="4910" y="283"/>
                  <a:pt x="4675" y="283"/>
                </a:cubicBezTo>
                <a:lnTo>
                  <a:pt x="2975" y="283"/>
                </a:lnTo>
                <a:cubicBezTo>
                  <a:pt x="2741" y="283"/>
                  <a:pt x="2550" y="410"/>
                  <a:pt x="2550" y="566"/>
                </a:cubicBezTo>
                <a:cubicBezTo>
                  <a:pt x="2550" y="410"/>
                  <a:pt x="2360" y="283"/>
                  <a:pt x="2125" y="283"/>
                </a:cubicBezTo>
                <a:lnTo>
                  <a:pt x="425" y="283"/>
                </a:lnTo>
                <a:cubicBezTo>
                  <a:pt x="191" y="283"/>
                  <a:pt x="0" y="156"/>
                  <a:pt x="0" y="0"/>
                </a:cubicBezTo>
              </a:path>
            </a:pathLst>
          </a:custGeom>
          <a:noFill/>
          <a:ln w="4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37" name="Rectangle 51"/>
          <p:cNvSpPr>
            <a:spLocks noChangeArrowheads="1"/>
          </p:cNvSpPr>
          <p:nvPr/>
        </p:nvSpPr>
        <p:spPr bwMode="auto">
          <a:xfrm>
            <a:off x="2408433" y="2516188"/>
            <a:ext cx="366820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1200" b="1">
                <a:solidFill>
                  <a:srgbClr val="0000FF"/>
                </a:solidFill>
                <a:cs typeface="Arial" charset="0"/>
              </a:rPr>
              <a:t>P1T1</a:t>
            </a:r>
            <a:endParaRPr lang="nl-NL">
              <a:cs typeface="Arial" charset="0"/>
            </a:endParaRPr>
          </a:p>
        </p:txBody>
      </p:sp>
      <p:sp>
        <p:nvSpPr>
          <p:cNvPr id="38" name="Rectangle 53"/>
          <p:cNvSpPr>
            <a:spLocks noChangeArrowheads="1"/>
          </p:cNvSpPr>
          <p:nvPr/>
        </p:nvSpPr>
        <p:spPr bwMode="auto">
          <a:xfrm>
            <a:off x="4811025" y="2536826"/>
            <a:ext cx="366820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1200" b="1" dirty="0" smtClean="0">
                <a:solidFill>
                  <a:srgbClr val="0000FF"/>
                </a:solidFill>
                <a:cs typeface="Arial" charset="0"/>
              </a:rPr>
              <a:t>P3T1</a:t>
            </a:r>
            <a:endParaRPr lang="nl-NL" dirty="0">
              <a:cs typeface="Arial" charset="0"/>
            </a:endParaRPr>
          </a:p>
        </p:txBody>
      </p:sp>
      <p:sp>
        <p:nvSpPr>
          <p:cNvPr id="39" name="Line 55"/>
          <p:cNvSpPr>
            <a:spLocks noChangeShapeType="1"/>
          </p:cNvSpPr>
          <p:nvPr/>
        </p:nvSpPr>
        <p:spPr bwMode="auto">
          <a:xfrm flipH="1" flipV="1">
            <a:off x="2222641" y="2617788"/>
            <a:ext cx="184204" cy="95250"/>
          </a:xfrm>
          <a:prstGeom prst="line">
            <a:avLst/>
          </a:prstGeom>
          <a:noFill/>
          <a:ln w="4" cap="rnd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0" name="Line 56"/>
          <p:cNvSpPr>
            <a:spLocks noChangeShapeType="1"/>
          </p:cNvSpPr>
          <p:nvPr/>
        </p:nvSpPr>
        <p:spPr bwMode="auto">
          <a:xfrm flipV="1">
            <a:off x="3791551" y="2617788"/>
            <a:ext cx="185792" cy="95250"/>
          </a:xfrm>
          <a:prstGeom prst="line">
            <a:avLst/>
          </a:prstGeom>
          <a:noFill/>
          <a:ln w="4" cap="rnd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1" name="Line 57"/>
          <p:cNvSpPr>
            <a:spLocks noChangeShapeType="1"/>
          </p:cNvSpPr>
          <p:nvPr/>
        </p:nvSpPr>
        <p:spPr bwMode="auto">
          <a:xfrm flipH="1" flipV="1">
            <a:off x="4576006" y="2617788"/>
            <a:ext cx="184204" cy="95250"/>
          </a:xfrm>
          <a:prstGeom prst="line">
            <a:avLst/>
          </a:prstGeom>
          <a:noFill/>
          <a:ln w="4" cap="rnd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2" name="Line 58"/>
          <p:cNvSpPr>
            <a:spLocks noChangeShapeType="1"/>
          </p:cNvSpPr>
          <p:nvPr/>
        </p:nvSpPr>
        <p:spPr bwMode="auto">
          <a:xfrm flipV="1">
            <a:off x="6181439" y="2619376"/>
            <a:ext cx="184204" cy="93663"/>
          </a:xfrm>
          <a:prstGeom prst="line">
            <a:avLst/>
          </a:prstGeom>
          <a:noFill/>
          <a:ln w="4" cap="rnd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3" name="Line 59"/>
          <p:cNvSpPr>
            <a:spLocks noChangeShapeType="1"/>
          </p:cNvSpPr>
          <p:nvPr/>
        </p:nvSpPr>
        <p:spPr bwMode="auto">
          <a:xfrm>
            <a:off x="2259165" y="2275682"/>
            <a:ext cx="4014376" cy="0"/>
          </a:xfrm>
          <a:prstGeom prst="line">
            <a:avLst/>
          </a:prstGeom>
          <a:noFill/>
          <a:ln w="4" cap="rnd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grpSp>
        <p:nvGrpSpPr>
          <p:cNvPr id="44" name="Group 62"/>
          <p:cNvGrpSpPr>
            <a:grpSpLocks/>
          </p:cNvGrpSpPr>
          <p:nvPr/>
        </p:nvGrpSpPr>
        <p:grpSpPr bwMode="auto">
          <a:xfrm>
            <a:off x="2543410" y="2209801"/>
            <a:ext cx="1246553" cy="131763"/>
            <a:chOff x="1572" y="1349"/>
            <a:chExt cx="785" cy="83"/>
          </a:xfrm>
        </p:grpSpPr>
        <p:sp>
          <p:nvSpPr>
            <p:cNvPr id="45" name="Rectangle 60"/>
            <p:cNvSpPr>
              <a:spLocks noChangeArrowheads="1"/>
            </p:cNvSpPr>
            <p:nvPr/>
          </p:nvSpPr>
          <p:spPr bwMode="auto">
            <a:xfrm>
              <a:off x="1572" y="1349"/>
              <a:ext cx="785" cy="83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  <p:sp>
          <p:nvSpPr>
            <p:cNvPr id="46" name="Rectangle 61"/>
            <p:cNvSpPr>
              <a:spLocks noChangeArrowheads="1"/>
            </p:cNvSpPr>
            <p:nvPr/>
          </p:nvSpPr>
          <p:spPr bwMode="auto">
            <a:xfrm>
              <a:off x="1572" y="1349"/>
              <a:ext cx="785" cy="83"/>
            </a:xfrm>
            <a:prstGeom prst="rect">
              <a:avLst/>
            </a:prstGeom>
            <a:noFill/>
            <a:ln w="4" cap="rnd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</p:grpSp>
      <p:sp>
        <p:nvSpPr>
          <p:cNvPr id="47" name="Rectangle 67"/>
          <p:cNvSpPr>
            <a:spLocks noChangeArrowheads="1"/>
          </p:cNvSpPr>
          <p:nvPr/>
        </p:nvSpPr>
        <p:spPr bwMode="auto">
          <a:xfrm>
            <a:off x="3019800" y="2208213"/>
            <a:ext cx="98454" cy="136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>
                <a:solidFill>
                  <a:srgbClr val="000000"/>
                </a:solidFill>
                <a:cs typeface="Arial" charset="0"/>
              </a:rPr>
              <a:t>5</a:t>
            </a:r>
            <a:endParaRPr lang="nl-NL">
              <a:cs typeface="Arial" charset="0"/>
            </a:endParaRPr>
          </a:p>
        </p:txBody>
      </p:sp>
      <p:sp>
        <p:nvSpPr>
          <p:cNvPr id="48" name="Rectangle 68"/>
          <p:cNvSpPr>
            <a:spLocks noChangeArrowheads="1"/>
          </p:cNvSpPr>
          <p:nvPr/>
        </p:nvSpPr>
        <p:spPr bwMode="auto">
          <a:xfrm>
            <a:off x="3073791" y="2208213"/>
            <a:ext cx="66695" cy="136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>
                <a:solidFill>
                  <a:srgbClr val="000000"/>
                </a:solidFill>
                <a:cs typeface="Arial" charset="0"/>
              </a:rPr>
              <a:t>’</a:t>
            </a:r>
            <a:endParaRPr lang="nl-NL">
              <a:cs typeface="Arial" charset="0"/>
            </a:endParaRPr>
          </a:p>
        </p:txBody>
      </p:sp>
      <p:sp>
        <p:nvSpPr>
          <p:cNvPr id="49" name="Rectangle 69"/>
          <p:cNvSpPr>
            <a:spLocks noChangeArrowheads="1"/>
          </p:cNvSpPr>
          <p:nvPr/>
        </p:nvSpPr>
        <p:spPr bwMode="auto">
          <a:xfrm>
            <a:off x="3121430" y="2208213"/>
            <a:ext cx="254074" cy="136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>
                <a:solidFill>
                  <a:srgbClr val="000000"/>
                </a:solidFill>
                <a:cs typeface="Arial" charset="0"/>
              </a:rPr>
              <a:t>flank</a:t>
            </a:r>
            <a:endParaRPr lang="nl-NL">
              <a:cs typeface="Arial" charset="0"/>
            </a:endParaRPr>
          </a:p>
        </p:txBody>
      </p:sp>
      <p:grpSp>
        <p:nvGrpSpPr>
          <p:cNvPr id="50" name="Group 75"/>
          <p:cNvGrpSpPr>
            <a:grpSpLocks/>
          </p:cNvGrpSpPr>
          <p:nvPr/>
        </p:nvGrpSpPr>
        <p:grpSpPr bwMode="auto">
          <a:xfrm>
            <a:off x="4758622" y="2209801"/>
            <a:ext cx="1292604" cy="131763"/>
            <a:chOff x="2967" y="1349"/>
            <a:chExt cx="814" cy="83"/>
          </a:xfrm>
        </p:grpSpPr>
        <p:sp>
          <p:nvSpPr>
            <p:cNvPr id="51" name="Rectangle 73"/>
            <p:cNvSpPr>
              <a:spLocks noChangeArrowheads="1"/>
            </p:cNvSpPr>
            <p:nvPr/>
          </p:nvSpPr>
          <p:spPr bwMode="auto">
            <a:xfrm>
              <a:off x="2967" y="1349"/>
              <a:ext cx="814" cy="83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  <p:sp>
          <p:nvSpPr>
            <p:cNvPr id="52" name="Rectangle 74"/>
            <p:cNvSpPr>
              <a:spLocks noChangeArrowheads="1"/>
            </p:cNvSpPr>
            <p:nvPr/>
          </p:nvSpPr>
          <p:spPr bwMode="auto">
            <a:xfrm>
              <a:off x="2967" y="1349"/>
              <a:ext cx="814" cy="83"/>
            </a:xfrm>
            <a:prstGeom prst="rect">
              <a:avLst/>
            </a:prstGeom>
            <a:noFill/>
            <a:ln w="4" cap="rnd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</p:grpSp>
      <p:sp>
        <p:nvSpPr>
          <p:cNvPr id="53" name="Rectangle 76"/>
          <p:cNvSpPr>
            <a:spLocks noChangeArrowheads="1"/>
          </p:cNvSpPr>
          <p:nvPr/>
        </p:nvSpPr>
        <p:spPr bwMode="auto">
          <a:xfrm>
            <a:off x="5188960" y="2228851"/>
            <a:ext cx="98454" cy="136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>
                <a:solidFill>
                  <a:srgbClr val="000000"/>
                </a:solidFill>
                <a:cs typeface="Arial" charset="0"/>
              </a:rPr>
              <a:t>3</a:t>
            </a:r>
            <a:endParaRPr lang="nl-NL">
              <a:cs typeface="Arial" charset="0"/>
            </a:endParaRPr>
          </a:p>
        </p:txBody>
      </p:sp>
      <p:sp>
        <p:nvSpPr>
          <p:cNvPr id="54" name="Rectangle 77"/>
          <p:cNvSpPr>
            <a:spLocks noChangeArrowheads="1"/>
          </p:cNvSpPr>
          <p:nvPr/>
        </p:nvSpPr>
        <p:spPr bwMode="auto">
          <a:xfrm>
            <a:off x="5242951" y="2228851"/>
            <a:ext cx="66695" cy="136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>
                <a:solidFill>
                  <a:srgbClr val="000000"/>
                </a:solidFill>
                <a:cs typeface="Arial" charset="0"/>
              </a:rPr>
              <a:t>’</a:t>
            </a:r>
            <a:endParaRPr lang="nl-NL">
              <a:cs typeface="Arial" charset="0"/>
            </a:endParaRPr>
          </a:p>
        </p:txBody>
      </p:sp>
      <p:sp>
        <p:nvSpPr>
          <p:cNvPr id="55" name="Rectangle 78"/>
          <p:cNvSpPr>
            <a:spLocks noChangeArrowheads="1"/>
          </p:cNvSpPr>
          <p:nvPr/>
        </p:nvSpPr>
        <p:spPr bwMode="auto">
          <a:xfrm>
            <a:off x="5290590" y="2228851"/>
            <a:ext cx="254074" cy="136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>
                <a:solidFill>
                  <a:srgbClr val="000000"/>
                </a:solidFill>
                <a:cs typeface="Arial" charset="0"/>
              </a:rPr>
              <a:t>flank</a:t>
            </a:r>
            <a:endParaRPr lang="nl-NL">
              <a:cs typeface="Arial" charset="0"/>
            </a:endParaRPr>
          </a:p>
        </p:txBody>
      </p:sp>
      <p:grpSp>
        <p:nvGrpSpPr>
          <p:cNvPr id="56" name="Group 82"/>
          <p:cNvGrpSpPr>
            <a:grpSpLocks/>
          </p:cNvGrpSpPr>
          <p:nvPr/>
        </p:nvGrpSpPr>
        <p:grpSpPr bwMode="auto">
          <a:xfrm>
            <a:off x="2543410" y="2209801"/>
            <a:ext cx="1246553" cy="131763"/>
            <a:chOff x="1572" y="1349"/>
            <a:chExt cx="785" cy="83"/>
          </a:xfrm>
        </p:grpSpPr>
        <p:sp>
          <p:nvSpPr>
            <p:cNvPr id="57" name="Rectangle 80"/>
            <p:cNvSpPr>
              <a:spLocks noChangeArrowheads="1"/>
            </p:cNvSpPr>
            <p:nvPr/>
          </p:nvSpPr>
          <p:spPr bwMode="auto">
            <a:xfrm>
              <a:off x="1572" y="1349"/>
              <a:ext cx="785" cy="83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  <p:sp>
          <p:nvSpPr>
            <p:cNvPr id="58" name="Rectangle 81"/>
            <p:cNvSpPr>
              <a:spLocks noChangeArrowheads="1"/>
            </p:cNvSpPr>
            <p:nvPr/>
          </p:nvSpPr>
          <p:spPr bwMode="auto">
            <a:xfrm>
              <a:off x="1572" y="1349"/>
              <a:ext cx="785" cy="83"/>
            </a:xfrm>
            <a:prstGeom prst="rect">
              <a:avLst/>
            </a:prstGeom>
            <a:noFill/>
            <a:ln w="4" cap="rnd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</p:grpSp>
      <p:grpSp>
        <p:nvGrpSpPr>
          <p:cNvPr id="59" name="Group 85"/>
          <p:cNvGrpSpPr>
            <a:grpSpLocks/>
          </p:cNvGrpSpPr>
          <p:nvPr/>
        </p:nvGrpSpPr>
        <p:grpSpPr bwMode="auto">
          <a:xfrm>
            <a:off x="3788375" y="2208243"/>
            <a:ext cx="960719" cy="133350"/>
            <a:chOff x="2356" y="1349"/>
            <a:chExt cx="605" cy="84"/>
          </a:xfrm>
        </p:grpSpPr>
        <p:sp>
          <p:nvSpPr>
            <p:cNvPr id="60" name="Rectangle 83"/>
            <p:cNvSpPr>
              <a:spLocks noChangeArrowheads="1"/>
            </p:cNvSpPr>
            <p:nvPr/>
          </p:nvSpPr>
          <p:spPr bwMode="auto">
            <a:xfrm>
              <a:off x="2356" y="1349"/>
              <a:ext cx="605" cy="84"/>
            </a:xfrm>
            <a:prstGeom prst="rect">
              <a:avLst/>
            </a:prstGeom>
            <a:solidFill>
              <a:srgbClr val="33CC33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  <p:sp>
          <p:nvSpPr>
            <p:cNvPr id="61" name="Rectangle 84"/>
            <p:cNvSpPr>
              <a:spLocks noChangeArrowheads="1"/>
            </p:cNvSpPr>
            <p:nvPr/>
          </p:nvSpPr>
          <p:spPr bwMode="auto">
            <a:xfrm>
              <a:off x="2356" y="1349"/>
              <a:ext cx="605" cy="84"/>
            </a:xfrm>
            <a:prstGeom prst="rect">
              <a:avLst/>
            </a:prstGeom>
            <a:noFill/>
            <a:ln w="4" cap="rnd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</p:grpSp>
      <p:sp>
        <p:nvSpPr>
          <p:cNvPr id="62" name="Rectangle 86"/>
          <p:cNvSpPr>
            <a:spLocks noChangeArrowheads="1"/>
          </p:cNvSpPr>
          <p:nvPr/>
        </p:nvSpPr>
        <p:spPr bwMode="auto">
          <a:xfrm>
            <a:off x="6481564" y="2213769"/>
            <a:ext cx="427163" cy="136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 dirty="0" err="1">
                <a:solidFill>
                  <a:srgbClr val="000000"/>
                </a:solidFill>
                <a:cs typeface="Arial" charset="0"/>
              </a:rPr>
              <a:t>Genome</a:t>
            </a:r>
            <a:endParaRPr lang="nl-NL" dirty="0">
              <a:cs typeface="Arial" charset="0"/>
            </a:endParaRPr>
          </a:p>
        </p:txBody>
      </p:sp>
      <p:sp>
        <p:nvSpPr>
          <p:cNvPr id="63" name="Rectangle 87"/>
          <p:cNvSpPr>
            <a:spLocks noChangeArrowheads="1"/>
          </p:cNvSpPr>
          <p:nvPr/>
        </p:nvSpPr>
        <p:spPr bwMode="auto">
          <a:xfrm>
            <a:off x="3019800" y="2208213"/>
            <a:ext cx="98454" cy="136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 dirty="0">
                <a:solidFill>
                  <a:srgbClr val="000000"/>
                </a:solidFill>
                <a:cs typeface="Arial" charset="0"/>
              </a:rPr>
              <a:t>5</a:t>
            </a:r>
            <a:endParaRPr lang="nl-NL" dirty="0">
              <a:cs typeface="Arial" charset="0"/>
            </a:endParaRPr>
          </a:p>
        </p:txBody>
      </p:sp>
      <p:sp>
        <p:nvSpPr>
          <p:cNvPr id="64" name="Rectangle 88"/>
          <p:cNvSpPr>
            <a:spLocks noChangeArrowheads="1"/>
          </p:cNvSpPr>
          <p:nvPr/>
        </p:nvSpPr>
        <p:spPr bwMode="auto">
          <a:xfrm>
            <a:off x="3073791" y="2208213"/>
            <a:ext cx="66695" cy="136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 dirty="0">
                <a:solidFill>
                  <a:srgbClr val="000000"/>
                </a:solidFill>
                <a:cs typeface="Arial" charset="0"/>
              </a:rPr>
              <a:t>’</a:t>
            </a:r>
            <a:endParaRPr lang="nl-NL" dirty="0">
              <a:cs typeface="Arial" charset="0"/>
            </a:endParaRPr>
          </a:p>
        </p:txBody>
      </p:sp>
      <p:sp>
        <p:nvSpPr>
          <p:cNvPr id="65" name="Rectangle 89"/>
          <p:cNvSpPr>
            <a:spLocks noChangeArrowheads="1"/>
          </p:cNvSpPr>
          <p:nvPr/>
        </p:nvSpPr>
        <p:spPr bwMode="auto">
          <a:xfrm>
            <a:off x="3121430" y="2208213"/>
            <a:ext cx="254074" cy="136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 dirty="0">
                <a:solidFill>
                  <a:srgbClr val="000000"/>
                </a:solidFill>
                <a:cs typeface="Arial" charset="0"/>
              </a:rPr>
              <a:t>flank</a:t>
            </a:r>
            <a:endParaRPr lang="nl-NL" dirty="0">
              <a:cs typeface="Arial" charset="0"/>
            </a:endParaRPr>
          </a:p>
        </p:txBody>
      </p:sp>
      <p:grpSp>
        <p:nvGrpSpPr>
          <p:cNvPr id="66" name="Group 95"/>
          <p:cNvGrpSpPr>
            <a:grpSpLocks/>
          </p:cNvGrpSpPr>
          <p:nvPr/>
        </p:nvGrpSpPr>
        <p:grpSpPr bwMode="auto">
          <a:xfrm>
            <a:off x="4758622" y="2209801"/>
            <a:ext cx="1292604" cy="131763"/>
            <a:chOff x="2967" y="1349"/>
            <a:chExt cx="814" cy="83"/>
          </a:xfrm>
        </p:grpSpPr>
        <p:sp>
          <p:nvSpPr>
            <p:cNvPr id="67" name="Rectangle 93"/>
            <p:cNvSpPr>
              <a:spLocks noChangeArrowheads="1"/>
            </p:cNvSpPr>
            <p:nvPr/>
          </p:nvSpPr>
          <p:spPr bwMode="auto">
            <a:xfrm>
              <a:off x="2967" y="1349"/>
              <a:ext cx="814" cy="83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  <p:sp>
          <p:nvSpPr>
            <p:cNvPr id="68" name="Rectangle 94"/>
            <p:cNvSpPr>
              <a:spLocks noChangeArrowheads="1"/>
            </p:cNvSpPr>
            <p:nvPr/>
          </p:nvSpPr>
          <p:spPr bwMode="auto">
            <a:xfrm>
              <a:off x="2967" y="1349"/>
              <a:ext cx="814" cy="83"/>
            </a:xfrm>
            <a:prstGeom prst="rect">
              <a:avLst/>
            </a:prstGeom>
            <a:noFill/>
            <a:ln w="4" cap="rnd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</p:grpSp>
      <p:sp>
        <p:nvSpPr>
          <p:cNvPr id="69" name="Rectangle 96"/>
          <p:cNvSpPr>
            <a:spLocks noChangeArrowheads="1"/>
          </p:cNvSpPr>
          <p:nvPr/>
        </p:nvSpPr>
        <p:spPr bwMode="auto">
          <a:xfrm>
            <a:off x="5188960" y="2208213"/>
            <a:ext cx="98454" cy="136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 dirty="0">
                <a:solidFill>
                  <a:srgbClr val="000000"/>
                </a:solidFill>
                <a:cs typeface="Arial" charset="0"/>
              </a:rPr>
              <a:t>3</a:t>
            </a:r>
            <a:endParaRPr lang="nl-NL" dirty="0">
              <a:cs typeface="Arial" charset="0"/>
            </a:endParaRPr>
          </a:p>
        </p:txBody>
      </p:sp>
      <p:sp>
        <p:nvSpPr>
          <p:cNvPr id="70" name="Rectangle 97"/>
          <p:cNvSpPr>
            <a:spLocks noChangeArrowheads="1"/>
          </p:cNvSpPr>
          <p:nvPr/>
        </p:nvSpPr>
        <p:spPr bwMode="auto">
          <a:xfrm>
            <a:off x="5242951" y="2208213"/>
            <a:ext cx="66695" cy="136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>
                <a:solidFill>
                  <a:srgbClr val="000000"/>
                </a:solidFill>
                <a:cs typeface="Arial" charset="0"/>
              </a:rPr>
              <a:t>’</a:t>
            </a:r>
            <a:endParaRPr lang="nl-NL">
              <a:cs typeface="Arial" charset="0"/>
            </a:endParaRPr>
          </a:p>
        </p:txBody>
      </p:sp>
      <p:sp>
        <p:nvSpPr>
          <p:cNvPr id="71" name="Rectangle 98"/>
          <p:cNvSpPr>
            <a:spLocks noChangeArrowheads="1"/>
          </p:cNvSpPr>
          <p:nvPr/>
        </p:nvSpPr>
        <p:spPr bwMode="auto">
          <a:xfrm>
            <a:off x="5290590" y="2208213"/>
            <a:ext cx="254074" cy="136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>
                <a:solidFill>
                  <a:srgbClr val="000000"/>
                </a:solidFill>
                <a:cs typeface="Arial" charset="0"/>
              </a:rPr>
              <a:t>flank</a:t>
            </a:r>
            <a:endParaRPr lang="nl-NL">
              <a:cs typeface="Arial" charset="0"/>
            </a:endParaRPr>
          </a:p>
        </p:txBody>
      </p:sp>
      <p:sp>
        <p:nvSpPr>
          <p:cNvPr id="72" name="Rectangle 99"/>
          <p:cNvSpPr>
            <a:spLocks noChangeArrowheads="1"/>
          </p:cNvSpPr>
          <p:nvPr/>
        </p:nvSpPr>
        <p:spPr bwMode="auto">
          <a:xfrm>
            <a:off x="1741488" y="2589213"/>
            <a:ext cx="165148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1200" b="1">
                <a:solidFill>
                  <a:srgbClr val="000000"/>
                </a:solidFill>
                <a:latin typeface="Trebuchet MS" pitchFamily="34" charset="0"/>
                <a:cs typeface="Arial" charset="0"/>
              </a:rPr>
              <a:t>A</a:t>
            </a:r>
            <a:endParaRPr lang="nl-NL">
              <a:cs typeface="Arial" charset="0"/>
            </a:endParaRPr>
          </a:p>
        </p:txBody>
      </p:sp>
      <p:sp>
        <p:nvSpPr>
          <p:cNvPr id="73" name="Rectangle 100"/>
          <p:cNvSpPr>
            <a:spLocks noChangeArrowheads="1"/>
          </p:cNvSpPr>
          <p:nvPr/>
        </p:nvSpPr>
        <p:spPr bwMode="auto">
          <a:xfrm>
            <a:off x="1754192" y="3587751"/>
            <a:ext cx="158797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1200" b="1">
                <a:solidFill>
                  <a:srgbClr val="000000"/>
                </a:solidFill>
                <a:latin typeface="Trebuchet MS" pitchFamily="34" charset="0"/>
                <a:cs typeface="Arial" charset="0"/>
              </a:rPr>
              <a:t>B</a:t>
            </a:r>
            <a:endParaRPr lang="nl-NL">
              <a:cs typeface="Arial" charset="0"/>
            </a:endParaRPr>
          </a:p>
        </p:txBody>
      </p:sp>
      <p:sp>
        <p:nvSpPr>
          <p:cNvPr id="74" name="Rectangle 101"/>
          <p:cNvSpPr>
            <a:spLocks noChangeArrowheads="1"/>
          </p:cNvSpPr>
          <p:nvPr/>
        </p:nvSpPr>
        <p:spPr bwMode="auto">
          <a:xfrm>
            <a:off x="1743076" y="4633913"/>
            <a:ext cx="161972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1200" b="1">
                <a:solidFill>
                  <a:srgbClr val="000000"/>
                </a:solidFill>
                <a:latin typeface="Trebuchet MS" pitchFamily="34" charset="0"/>
                <a:cs typeface="Arial" charset="0"/>
              </a:rPr>
              <a:t>C</a:t>
            </a:r>
            <a:endParaRPr lang="nl-NL">
              <a:cs typeface="Arial" charset="0"/>
            </a:endParaRPr>
          </a:p>
        </p:txBody>
      </p:sp>
      <p:sp>
        <p:nvSpPr>
          <p:cNvPr id="75" name="Rectangle 103"/>
          <p:cNvSpPr>
            <a:spLocks noChangeArrowheads="1"/>
          </p:cNvSpPr>
          <p:nvPr/>
        </p:nvSpPr>
        <p:spPr bwMode="auto">
          <a:xfrm>
            <a:off x="3404087" y="4041776"/>
            <a:ext cx="203260" cy="136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>
                <a:solidFill>
                  <a:srgbClr val="000000"/>
                </a:solidFill>
                <a:cs typeface="Arial" charset="0"/>
              </a:rPr>
              <a:t>3kb</a:t>
            </a:r>
            <a:endParaRPr lang="nl-NL">
              <a:cs typeface="Arial" charset="0"/>
            </a:endParaRPr>
          </a:p>
        </p:txBody>
      </p:sp>
      <p:sp>
        <p:nvSpPr>
          <p:cNvPr id="76" name="Rectangle 104"/>
          <p:cNvSpPr>
            <a:spLocks noChangeArrowheads="1"/>
          </p:cNvSpPr>
          <p:nvPr/>
        </p:nvSpPr>
        <p:spPr bwMode="auto">
          <a:xfrm>
            <a:off x="2642394" y="3821881"/>
            <a:ext cx="1157627" cy="57150"/>
          </a:xfrm>
          <a:prstGeom prst="rect">
            <a:avLst/>
          </a:prstGeom>
          <a:solidFill>
            <a:srgbClr val="FF0000"/>
          </a:solidFill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en-US">
              <a:latin typeface="Calibri" pitchFamily="34" charset="0"/>
            </a:endParaRPr>
          </a:p>
        </p:txBody>
      </p:sp>
      <p:sp>
        <p:nvSpPr>
          <p:cNvPr id="77" name="Rectangle 105"/>
          <p:cNvSpPr>
            <a:spLocks noChangeArrowheads="1"/>
          </p:cNvSpPr>
          <p:nvPr/>
        </p:nvSpPr>
        <p:spPr bwMode="auto">
          <a:xfrm>
            <a:off x="2638687" y="3819442"/>
            <a:ext cx="1148099" cy="53975"/>
          </a:xfrm>
          <a:prstGeom prst="rect">
            <a:avLst/>
          </a:prstGeom>
          <a:noFill/>
          <a:ln w="4" cap="rnd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>
              <a:latin typeface="Calibri" pitchFamily="34" charset="0"/>
            </a:endParaRPr>
          </a:p>
        </p:txBody>
      </p:sp>
      <p:sp>
        <p:nvSpPr>
          <p:cNvPr id="78" name="Rectangle 107"/>
          <p:cNvSpPr>
            <a:spLocks noChangeArrowheads="1"/>
          </p:cNvSpPr>
          <p:nvPr/>
        </p:nvSpPr>
        <p:spPr bwMode="auto">
          <a:xfrm>
            <a:off x="4838020" y="3416301"/>
            <a:ext cx="1170330" cy="52388"/>
          </a:xfrm>
          <a:prstGeom prst="rect">
            <a:avLst/>
          </a:prstGeom>
          <a:solidFill>
            <a:srgbClr val="FF0000"/>
          </a:solidFill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en-US">
              <a:latin typeface="Calibri" pitchFamily="34" charset="0"/>
            </a:endParaRPr>
          </a:p>
        </p:txBody>
      </p:sp>
      <p:sp>
        <p:nvSpPr>
          <p:cNvPr id="79" name="Rectangle 111"/>
          <p:cNvSpPr>
            <a:spLocks noChangeArrowheads="1"/>
          </p:cNvSpPr>
          <p:nvPr/>
        </p:nvSpPr>
        <p:spPr bwMode="auto">
          <a:xfrm>
            <a:off x="5052395" y="3629026"/>
            <a:ext cx="203260" cy="136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>
                <a:solidFill>
                  <a:srgbClr val="000000"/>
                </a:solidFill>
                <a:cs typeface="Arial" charset="0"/>
              </a:rPr>
              <a:t>3kb</a:t>
            </a:r>
            <a:endParaRPr lang="nl-NL">
              <a:cs typeface="Arial" charset="0"/>
            </a:endParaRPr>
          </a:p>
        </p:txBody>
      </p:sp>
      <p:sp>
        <p:nvSpPr>
          <p:cNvPr id="80" name="Freeform 113"/>
          <p:cNvSpPr>
            <a:spLocks noEditPoints="1"/>
          </p:cNvSpPr>
          <p:nvPr/>
        </p:nvSpPr>
        <p:spPr bwMode="auto">
          <a:xfrm>
            <a:off x="5700285" y="3651251"/>
            <a:ext cx="281070" cy="50800"/>
          </a:xfrm>
          <a:custGeom>
            <a:avLst/>
            <a:gdLst>
              <a:gd name="T0" fmla="*/ 174 w 1154"/>
              <a:gd name="T1" fmla="*/ 19 h 200"/>
              <a:gd name="T2" fmla="*/ 25 w 1154"/>
              <a:gd name="T3" fmla="*/ 19 h 200"/>
              <a:gd name="T4" fmla="*/ 23 w 1154"/>
              <a:gd name="T5" fmla="*/ 16 h 200"/>
              <a:gd name="T6" fmla="*/ 25 w 1154"/>
              <a:gd name="T7" fmla="*/ 13 h 200"/>
              <a:gd name="T8" fmla="*/ 174 w 1154"/>
              <a:gd name="T9" fmla="*/ 13 h 200"/>
              <a:gd name="T10" fmla="*/ 177 w 1154"/>
              <a:gd name="T11" fmla="*/ 16 h 200"/>
              <a:gd name="T12" fmla="*/ 174 w 1154"/>
              <a:gd name="T13" fmla="*/ 19 h 200"/>
              <a:gd name="T14" fmla="*/ 31 w 1154"/>
              <a:gd name="T15" fmla="*/ 32 h 200"/>
              <a:gd name="T16" fmla="*/ 0 w 1154"/>
              <a:gd name="T17" fmla="*/ 16 h 200"/>
              <a:gd name="T18" fmla="*/ 31 w 1154"/>
              <a:gd name="T19" fmla="*/ 0 h 200"/>
              <a:gd name="T20" fmla="*/ 31 w 1154"/>
              <a:gd name="T21" fmla="*/ 32 h 2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1154"/>
              <a:gd name="T34" fmla="*/ 0 h 200"/>
              <a:gd name="T35" fmla="*/ 1154 w 1154"/>
              <a:gd name="T36" fmla="*/ 200 h 2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1154" h="200">
                <a:moveTo>
                  <a:pt x="1137" y="116"/>
                </a:moveTo>
                <a:lnTo>
                  <a:pt x="166" y="116"/>
                </a:lnTo>
                <a:cubicBezTo>
                  <a:pt x="157" y="116"/>
                  <a:pt x="150" y="109"/>
                  <a:pt x="150" y="100"/>
                </a:cubicBezTo>
                <a:cubicBezTo>
                  <a:pt x="150" y="90"/>
                  <a:pt x="157" y="83"/>
                  <a:pt x="166" y="83"/>
                </a:cubicBezTo>
                <a:lnTo>
                  <a:pt x="1137" y="83"/>
                </a:lnTo>
                <a:cubicBezTo>
                  <a:pt x="1146" y="83"/>
                  <a:pt x="1154" y="90"/>
                  <a:pt x="1154" y="100"/>
                </a:cubicBezTo>
                <a:cubicBezTo>
                  <a:pt x="1154" y="109"/>
                  <a:pt x="1146" y="116"/>
                  <a:pt x="1137" y="116"/>
                </a:cubicBezTo>
                <a:close/>
                <a:moveTo>
                  <a:pt x="200" y="200"/>
                </a:moveTo>
                <a:lnTo>
                  <a:pt x="0" y="100"/>
                </a:lnTo>
                <a:lnTo>
                  <a:pt x="200" y="0"/>
                </a:lnTo>
                <a:lnTo>
                  <a:pt x="200" y="20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81" name="Rectangle 116"/>
          <p:cNvSpPr>
            <a:spLocks noChangeArrowheads="1"/>
          </p:cNvSpPr>
          <p:nvPr/>
        </p:nvSpPr>
        <p:spPr bwMode="auto">
          <a:xfrm>
            <a:off x="4129787" y="3409951"/>
            <a:ext cx="714584" cy="57150"/>
          </a:xfrm>
          <a:prstGeom prst="rect">
            <a:avLst/>
          </a:prstGeom>
          <a:solidFill>
            <a:srgbClr val="33CC33"/>
          </a:solidFill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en-US">
              <a:latin typeface="Calibri" pitchFamily="34" charset="0"/>
            </a:endParaRPr>
          </a:p>
        </p:txBody>
      </p:sp>
      <p:sp>
        <p:nvSpPr>
          <p:cNvPr id="82" name="Rectangle 117"/>
          <p:cNvSpPr>
            <a:spLocks noChangeArrowheads="1"/>
          </p:cNvSpPr>
          <p:nvPr/>
        </p:nvSpPr>
        <p:spPr bwMode="auto">
          <a:xfrm>
            <a:off x="4129787" y="3409951"/>
            <a:ext cx="714584" cy="57150"/>
          </a:xfrm>
          <a:prstGeom prst="rect">
            <a:avLst/>
          </a:prstGeom>
          <a:noFill/>
          <a:ln w="4" cap="rnd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>
              <a:latin typeface="Calibri" pitchFamily="34" charset="0"/>
            </a:endParaRPr>
          </a:p>
        </p:txBody>
      </p:sp>
      <p:sp>
        <p:nvSpPr>
          <p:cNvPr id="83" name="Rectangle 119"/>
          <p:cNvSpPr>
            <a:spLocks noChangeArrowheads="1"/>
          </p:cNvSpPr>
          <p:nvPr/>
        </p:nvSpPr>
        <p:spPr bwMode="auto">
          <a:xfrm>
            <a:off x="3758203" y="3821113"/>
            <a:ext cx="674885" cy="49213"/>
          </a:xfrm>
          <a:prstGeom prst="rect">
            <a:avLst/>
          </a:prstGeom>
          <a:solidFill>
            <a:srgbClr val="33CC33"/>
          </a:solidFill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en-US">
              <a:latin typeface="Calibri" pitchFamily="34" charset="0"/>
            </a:endParaRPr>
          </a:p>
        </p:txBody>
      </p:sp>
      <p:sp>
        <p:nvSpPr>
          <p:cNvPr id="84" name="Rectangle 120"/>
          <p:cNvSpPr>
            <a:spLocks noChangeArrowheads="1"/>
          </p:cNvSpPr>
          <p:nvPr/>
        </p:nvSpPr>
        <p:spPr bwMode="auto">
          <a:xfrm>
            <a:off x="3794726" y="3821113"/>
            <a:ext cx="674885" cy="49213"/>
          </a:xfrm>
          <a:prstGeom prst="rect">
            <a:avLst/>
          </a:prstGeom>
          <a:noFill/>
          <a:ln w="4" cap="rnd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>
              <a:latin typeface="Calibri" pitchFamily="34" charset="0"/>
            </a:endParaRPr>
          </a:p>
        </p:txBody>
      </p:sp>
      <p:sp>
        <p:nvSpPr>
          <p:cNvPr id="85" name="Freeform 122"/>
          <p:cNvSpPr>
            <a:spLocks noEditPoints="1"/>
          </p:cNvSpPr>
          <p:nvPr/>
        </p:nvSpPr>
        <p:spPr bwMode="auto">
          <a:xfrm>
            <a:off x="4185366" y="4084638"/>
            <a:ext cx="281070" cy="50800"/>
          </a:xfrm>
          <a:custGeom>
            <a:avLst/>
            <a:gdLst>
              <a:gd name="T0" fmla="*/ 174 w 2308"/>
              <a:gd name="T1" fmla="*/ 19 h 400"/>
              <a:gd name="T2" fmla="*/ 26 w 2308"/>
              <a:gd name="T3" fmla="*/ 19 h 400"/>
              <a:gd name="T4" fmla="*/ 23 w 2308"/>
              <a:gd name="T5" fmla="*/ 16 h 400"/>
              <a:gd name="T6" fmla="*/ 26 w 2308"/>
              <a:gd name="T7" fmla="*/ 13 h 400"/>
              <a:gd name="T8" fmla="*/ 174 w 2308"/>
              <a:gd name="T9" fmla="*/ 13 h 400"/>
              <a:gd name="T10" fmla="*/ 177 w 2308"/>
              <a:gd name="T11" fmla="*/ 16 h 400"/>
              <a:gd name="T12" fmla="*/ 174 w 2308"/>
              <a:gd name="T13" fmla="*/ 19 h 400"/>
              <a:gd name="T14" fmla="*/ 31 w 2308"/>
              <a:gd name="T15" fmla="*/ 32 h 400"/>
              <a:gd name="T16" fmla="*/ 0 w 2308"/>
              <a:gd name="T17" fmla="*/ 16 h 400"/>
              <a:gd name="T18" fmla="*/ 31 w 2308"/>
              <a:gd name="T19" fmla="*/ 0 h 400"/>
              <a:gd name="T20" fmla="*/ 31 w 2308"/>
              <a:gd name="T21" fmla="*/ 32 h 4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2308"/>
              <a:gd name="T34" fmla="*/ 0 h 400"/>
              <a:gd name="T35" fmla="*/ 2308 w 2308"/>
              <a:gd name="T36" fmla="*/ 400 h 4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2308" h="400">
                <a:moveTo>
                  <a:pt x="2275" y="233"/>
                </a:moveTo>
                <a:lnTo>
                  <a:pt x="333" y="233"/>
                </a:lnTo>
                <a:cubicBezTo>
                  <a:pt x="315" y="233"/>
                  <a:pt x="300" y="219"/>
                  <a:pt x="300" y="200"/>
                </a:cubicBezTo>
                <a:cubicBezTo>
                  <a:pt x="300" y="182"/>
                  <a:pt x="315" y="167"/>
                  <a:pt x="333" y="167"/>
                </a:cubicBezTo>
                <a:lnTo>
                  <a:pt x="2275" y="167"/>
                </a:lnTo>
                <a:cubicBezTo>
                  <a:pt x="2293" y="167"/>
                  <a:pt x="2308" y="182"/>
                  <a:pt x="2308" y="200"/>
                </a:cubicBezTo>
                <a:cubicBezTo>
                  <a:pt x="2308" y="219"/>
                  <a:pt x="2293" y="233"/>
                  <a:pt x="2275" y="233"/>
                </a:cubicBezTo>
                <a:close/>
                <a:moveTo>
                  <a:pt x="400" y="400"/>
                </a:moveTo>
                <a:lnTo>
                  <a:pt x="0" y="200"/>
                </a:lnTo>
                <a:lnTo>
                  <a:pt x="400" y="0"/>
                </a:lnTo>
                <a:lnTo>
                  <a:pt x="400" y="40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86" name="Freeform 123"/>
          <p:cNvSpPr>
            <a:spLocks noEditPoints="1"/>
          </p:cNvSpPr>
          <p:nvPr/>
        </p:nvSpPr>
        <p:spPr bwMode="auto">
          <a:xfrm>
            <a:off x="4144079" y="3659188"/>
            <a:ext cx="281070" cy="50800"/>
          </a:xfrm>
          <a:custGeom>
            <a:avLst/>
            <a:gdLst>
              <a:gd name="T0" fmla="*/ 3 w 2300"/>
              <a:gd name="T1" fmla="*/ 13 h 400"/>
              <a:gd name="T2" fmla="*/ 151 w 2300"/>
              <a:gd name="T3" fmla="*/ 13 h 400"/>
              <a:gd name="T4" fmla="*/ 154 w 2300"/>
              <a:gd name="T5" fmla="*/ 16 h 400"/>
              <a:gd name="T6" fmla="*/ 151 w 2300"/>
              <a:gd name="T7" fmla="*/ 19 h 400"/>
              <a:gd name="T8" fmla="*/ 3 w 2300"/>
              <a:gd name="T9" fmla="*/ 19 h 400"/>
              <a:gd name="T10" fmla="*/ 0 w 2300"/>
              <a:gd name="T11" fmla="*/ 16 h 400"/>
              <a:gd name="T12" fmla="*/ 3 w 2300"/>
              <a:gd name="T13" fmla="*/ 13 h 400"/>
              <a:gd name="T14" fmla="*/ 146 w 2300"/>
              <a:gd name="T15" fmla="*/ 0 h 400"/>
              <a:gd name="T16" fmla="*/ 177 w 2300"/>
              <a:gd name="T17" fmla="*/ 16 h 400"/>
              <a:gd name="T18" fmla="*/ 146 w 2300"/>
              <a:gd name="T19" fmla="*/ 32 h 400"/>
              <a:gd name="T20" fmla="*/ 146 w 2300"/>
              <a:gd name="T21" fmla="*/ 0 h 4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2300"/>
              <a:gd name="T34" fmla="*/ 0 h 400"/>
              <a:gd name="T35" fmla="*/ 2300 w 2300"/>
              <a:gd name="T36" fmla="*/ 400 h 4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2300" h="400">
                <a:moveTo>
                  <a:pt x="34" y="167"/>
                </a:moveTo>
                <a:lnTo>
                  <a:pt x="1967" y="167"/>
                </a:lnTo>
                <a:cubicBezTo>
                  <a:pt x="1986" y="167"/>
                  <a:pt x="2000" y="182"/>
                  <a:pt x="2000" y="200"/>
                </a:cubicBezTo>
                <a:cubicBezTo>
                  <a:pt x="2000" y="219"/>
                  <a:pt x="1986" y="234"/>
                  <a:pt x="1967" y="234"/>
                </a:cubicBezTo>
                <a:lnTo>
                  <a:pt x="34" y="234"/>
                </a:lnTo>
                <a:cubicBezTo>
                  <a:pt x="15" y="234"/>
                  <a:pt x="0" y="219"/>
                  <a:pt x="0" y="200"/>
                </a:cubicBezTo>
                <a:cubicBezTo>
                  <a:pt x="0" y="182"/>
                  <a:pt x="15" y="167"/>
                  <a:pt x="34" y="167"/>
                </a:cubicBezTo>
                <a:close/>
                <a:moveTo>
                  <a:pt x="1900" y="0"/>
                </a:moveTo>
                <a:lnTo>
                  <a:pt x="2300" y="200"/>
                </a:lnTo>
                <a:lnTo>
                  <a:pt x="1900" y="400"/>
                </a:lnTo>
                <a:lnTo>
                  <a:pt x="190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87" name="Freeform 126"/>
          <p:cNvSpPr>
            <a:spLocks/>
          </p:cNvSpPr>
          <p:nvPr/>
        </p:nvSpPr>
        <p:spPr bwMode="auto">
          <a:xfrm>
            <a:off x="2646628" y="3871913"/>
            <a:ext cx="1830924" cy="141288"/>
          </a:xfrm>
          <a:custGeom>
            <a:avLst/>
            <a:gdLst>
              <a:gd name="T0" fmla="*/ 1153 w 16317"/>
              <a:gd name="T1" fmla="*/ 0 h 1134"/>
              <a:gd name="T2" fmla="*/ 1057 w 16317"/>
              <a:gd name="T3" fmla="*/ 45 h 1134"/>
              <a:gd name="T4" fmla="*/ 673 w 16317"/>
              <a:gd name="T5" fmla="*/ 45 h 1134"/>
              <a:gd name="T6" fmla="*/ 577 w 16317"/>
              <a:gd name="T7" fmla="*/ 89 h 1134"/>
              <a:gd name="T8" fmla="*/ 480 w 16317"/>
              <a:gd name="T9" fmla="*/ 45 h 1134"/>
              <a:gd name="T10" fmla="*/ 96 w 16317"/>
              <a:gd name="T11" fmla="*/ 45 h 1134"/>
              <a:gd name="T12" fmla="*/ 0 w 16317"/>
              <a:gd name="T13" fmla="*/ 0 h 1134"/>
              <a:gd name="T14" fmla="*/ 0 60000 65536"/>
              <a:gd name="T15" fmla="*/ 0 60000 65536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w 16317"/>
              <a:gd name="T22" fmla="*/ 0 h 1134"/>
              <a:gd name="T23" fmla="*/ 16317 w 16317"/>
              <a:gd name="T24" fmla="*/ 1134 h 1134"/>
            </a:gdLst>
            <a:ahLst/>
            <a:cxnLst>
              <a:cxn ang="T14">
                <a:pos x="T0" y="T1"/>
              </a:cxn>
              <a:cxn ang="T15">
                <a:pos x="T2" y="T3"/>
              </a:cxn>
              <a:cxn ang="T16">
                <a:pos x="T4" y="T5"/>
              </a:cxn>
              <a:cxn ang="T17">
                <a:pos x="T6" y="T7"/>
              </a:cxn>
              <a:cxn ang="T18">
                <a:pos x="T8" y="T9"/>
              </a:cxn>
              <a:cxn ang="T19">
                <a:pos x="T10" y="T11"/>
              </a:cxn>
              <a:cxn ang="T20">
                <a:pos x="T12" y="T13"/>
              </a:cxn>
            </a:cxnLst>
            <a:rect l="T21" t="T22" r="T23" b="T24"/>
            <a:pathLst>
              <a:path w="16317" h="1134">
                <a:moveTo>
                  <a:pt x="16317" y="0"/>
                </a:moveTo>
                <a:cubicBezTo>
                  <a:pt x="16317" y="313"/>
                  <a:pt x="15708" y="567"/>
                  <a:pt x="14957" y="567"/>
                </a:cubicBezTo>
                <a:lnTo>
                  <a:pt x="9519" y="567"/>
                </a:lnTo>
                <a:cubicBezTo>
                  <a:pt x="8768" y="567"/>
                  <a:pt x="8159" y="821"/>
                  <a:pt x="8159" y="1134"/>
                </a:cubicBezTo>
                <a:cubicBezTo>
                  <a:pt x="8159" y="821"/>
                  <a:pt x="7550" y="567"/>
                  <a:pt x="6799" y="567"/>
                </a:cubicBezTo>
                <a:lnTo>
                  <a:pt x="1360" y="567"/>
                </a:lnTo>
                <a:cubicBezTo>
                  <a:pt x="609" y="567"/>
                  <a:pt x="0" y="313"/>
                  <a:pt x="0" y="0"/>
                </a:cubicBezTo>
              </a:path>
            </a:pathLst>
          </a:custGeom>
          <a:noFill/>
          <a:ln w="4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88" name="Rectangle 127"/>
          <p:cNvSpPr>
            <a:spLocks noChangeArrowheads="1"/>
          </p:cNvSpPr>
          <p:nvPr/>
        </p:nvSpPr>
        <p:spPr bwMode="auto">
          <a:xfrm>
            <a:off x="3404087" y="4041776"/>
            <a:ext cx="203260" cy="136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>
                <a:solidFill>
                  <a:srgbClr val="000000"/>
                </a:solidFill>
                <a:cs typeface="Arial" charset="0"/>
              </a:rPr>
              <a:t>3kb</a:t>
            </a:r>
            <a:endParaRPr lang="nl-NL">
              <a:cs typeface="Arial" charset="0"/>
            </a:endParaRPr>
          </a:p>
        </p:txBody>
      </p:sp>
      <p:sp>
        <p:nvSpPr>
          <p:cNvPr id="89" name="Rectangle 132"/>
          <p:cNvSpPr>
            <a:spLocks noChangeArrowheads="1"/>
          </p:cNvSpPr>
          <p:nvPr/>
        </p:nvSpPr>
        <p:spPr bwMode="auto">
          <a:xfrm>
            <a:off x="4838020" y="3416301"/>
            <a:ext cx="1170330" cy="49213"/>
          </a:xfrm>
          <a:prstGeom prst="rect">
            <a:avLst/>
          </a:prstGeom>
          <a:noFill/>
          <a:ln w="4" cap="rnd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>
              <a:latin typeface="Calibri" pitchFamily="34" charset="0"/>
            </a:endParaRPr>
          </a:p>
        </p:txBody>
      </p:sp>
      <p:sp>
        <p:nvSpPr>
          <p:cNvPr id="90" name="Freeform 134"/>
          <p:cNvSpPr>
            <a:spLocks/>
          </p:cNvSpPr>
          <p:nvPr/>
        </p:nvSpPr>
        <p:spPr bwMode="auto">
          <a:xfrm>
            <a:off x="4147255" y="3443288"/>
            <a:ext cx="1861095" cy="147638"/>
          </a:xfrm>
          <a:custGeom>
            <a:avLst/>
            <a:gdLst>
              <a:gd name="T0" fmla="*/ 1172 w 8238"/>
              <a:gd name="T1" fmla="*/ 0 h 488"/>
              <a:gd name="T2" fmla="*/ 1074 w 8238"/>
              <a:gd name="T3" fmla="*/ 47 h 488"/>
              <a:gd name="T4" fmla="*/ 684 w 8238"/>
              <a:gd name="T5" fmla="*/ 47 h 488"/>
              <a:gd name="T6" fmla="*/ 586 w 8238"/>
              <a:gd name="T7" fmla="*/ 93 h 488"/>
              <a:gd name="T8" fmla="*/ 488 w 8238"/>
              <a:gd name="T9" fmla="*/ 47 h 488"/>
              <a:gd name="T10" fmla="*/ 98 w 8238"/>
              <a:gd name="T11" fmla="*/ 47 h 488"/>
              <a:gd name="T12" fmla="*/ 0 w 8238"/>
              <a:gd name="T13" fmla="*/ 0 h 488"/>
              <a:gd name="T14" fmla="*/ 0 60000 65536"/>
              <a:gd name="T15" fmla="*/ 0 60000 65536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w 8238"/>
              <a:gd name="T22" fmla="*/ 0 h 488"/>
              <a:gd name="T23" fmla="*/ 8238 w 8238"/>
              <a:gd name="T24" fmla="*/ 488 h 488"/>
            </a:gdLst>
            <a:ahLst/>
            <a:cxnLst>
              <a:cxn ang="T14">
                <a:pos x="T0" y="T1"/>
              </a:cxn>
              <a:cxn ang="T15">
                <a:pos x="T2" y="T3"/>
              </a:cxn>
              <a:cxn ang="T16">
                <a:pos x="T4" y="T5"/>
              </a:cxn>
              <a:cxn ang="T17">
                <a:pos x="T6" y="T7"/>
              </a:cxn>
              <a:cxn ang="T18">
                <a:pos x="T8" y="T9"/>
              </a:cxn>
              <a:cxn ang="T19">
                <a:pos x="T10" y="T11"/>
              </a:cxn>
              <a:cxn ang="T20">
                <a:pos x="T12" y="T13"/>
              </a:cxn>
            </a:cxnLst>
            <a:rect l="T21" t="T22" r="T23" b="T24"/>
            <a:pathLst>
              <a:path w="8238" h="488">
                <a:moveTo>
                  <a:pt x="8238" y="0"/>
                </a:moveTo>
                <a:cubicBezTo>
                  <a:pt x="8238" y="135"/>
                  <a:pt x="7931" y="244"/>
                  <a:pt x="7552" y="244"/>
                </a:cubicBezTo>
                <a:lnTo>
                  <a:pt x="4806" y="244"/>
                </a:lnTo>
                <a:cubicBezTo>
                  <a:pt x="4427" y="244"/>
                  <a:pt x="4119" y="353"/>
                  <a:pt x="4119" y="488"/>
                </a:cubicBezTo>
                <a:cubicBezTo>
                  <a:pt x="4119" y="353"/>
                  <a:pt x="3812" y="244"/>
                  <a:pt x="3433" y="244"/>
                </a:cubicBezTo>
                <a:lnTo>
                  <a:pt x="687" y="244"/>
                </a:lnTo>
                <a:cubicBezTo>
                  <a:pt x="308" y="244"/>
                  <a:pt x="0" y="135"/>
                  <a:pt x="0" y="0"/>
                </a:cubicBezTo>
              </a:path>
            </a:pathLst>
          </a:custGeom>
          <a:noFill/>
          <a:ln w="4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91" name="Rectangle 135"/>
          <p:cNvSpPr>
            <a:spLocks noChangeArrowheads="1"/>
          </p:cNvSpPr>
          <p:nvPr/>
        </p:nvSpPr>
        <p:spPr bwMode="auto">
          <a:xfrm>
            <a:off x="5052395" y="3629026"/>
            <a:ext cx="203260" cy="136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>
                <a:solidFill>
                  <a:srgbClr val="000000"/>
                </a:solidFill>
                <a:cs typeface="Arial" charset="0"/>
              </a:rPr>
              <a:t>3kb</a:t>
            </a:r>
            <a:endParaRPr lang="nl-NL">
              <a:cs typeface="Arial" charset="0"/>
            </a:endParaRPr>
          </a:p>
        </p:txBody>
      </p:sp>
      <p:sp>
        <p:nvSpPr>
          <p:cNvPr id="92" name="Freeform 136"/>
          <p:cNvSpPr>
            <a:spLocks noEditPoints="1"/>
          </p:cNvSpPr>
          <p:nvPr/>
        </p:nvSpPr>
        <p:spPr bwMode="auto">
          <a:xfrm>
            <a:off x="2683151" y="4089401"/>
            <a:ext cx="281070" cy="49213"/>
          </a:xfrm>
          <a:custGeom>
            <a:avLst/>
            <a:gdLst>
              <a:gd name="T0" fmla="*/ 3 w 2300"/>
              <a:gd name="T1" fmla="*/ 13 h 400"/>
              <a:gd name="T2" fmla="*/ 151 w 2300"/>
              <a:gd name="T3" fmla="*/ 13 h 400"/>
              <a:gd name="T4" fmla="*/ 154 w 2300"/>
              <a:gd name="T5" fmla="*/ 16 h 400"/>
              <a:gd name="T6" fmla="*/ 151 w 2300"/>
              <a:gd name="T7" fmla="*/ 18 h 400"/>
              <a:gd name="T8" fmla="*/ 3 w 2300"/>
              <a:gd name="T9" fmla="*/ 18 h 400"/>
              <a:gd name="T10" fmla="*/ 0 w 2300"/>
              <a:gd name="T11" fmla="*/ 16 h 400"/>
              <a:gd name="T12" fmla="*/ 3 w 2300"/>
              <a:gd name="T13" fmla="*/ 13 h 400"/>
              <a:gd name="T14" fmla="*/ 146 w 2300"/>
              <a:gd name="T15" fmla="*/ 0 h 400"/>
              <a:gd name="T16" fmla="*/ 177 w 2300"/>
              <a:gd name="T17" fmla="*/ 16 h 400"/>
              <a:gd name="T18" fmla="*/ 146 w 2300"/>
              <a:gd name="T19" fmla="*/ 31 h 400"/>
              <a:gd name="T20" fmla="*/ 146 w 2300"/>
              <a:gd name="T21" fmla="*/ 0 h 4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2300"/>
              <a:gd name="T34" fmla="*/ 0 h 400"/>
              <a:gd name="T35" fmla="*/ 2300 w 2300"/>
              <a:gd name="T36" fmla="*/ 400 h 4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2300" h="400">
                <a:moveTo>
                  <a:pt x="34" y="167"/>
                </a:moveTo>
                <a:lnTo>
                  <a:pt x="1967" y="167"/>
                </a:lnTo>
                <a:cubicBezTo>
                  <a:pt x="1986" y="167"/>
                  <a:pt x="2000" y="182"/>
                  <a:pt x="2000" y="200"/>
                </a:cubicBezTo>
                <a:cubicBezTo>
                  <a:pt x="2000" y="219"/>
                  <a:pt x="1986" y="234"/>
                  <a:pt x="1967" y="234"/>
                </a:cubicBezTo>
                <a:lnTo>
                  <a:pt x="34" y="234"/>
                </a:lnTo>
                <a:cubicBezTo>
                  <a:pt x="15" y="234"/>
                  <a:pt x="0" y="219"/>
                  <a:pt x="0" y="200"/>
                </a:cubicBezTo>
                <a:cubicBezTo>
                  <a:pt x="0" y="182"/>
                  <a:pt x="15" y="167"/>
                  <a:pt x="34" y="167"/>
                </a:cubicBezTo>
                <a:close/>
                <a:moveTo>
                  <a:pt x="1900" y="0"/>
                </a:moveTo>
                <a:lnTo>
                  <a:pt x="2300" y="200"/>
                </a:lnTo>
                <a:lnTo>
                  <a:pt x="1900" y="400"/>
                </a:lnTo>
                <a:lnTo>
                  <a:pt x="190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93" name="Rectangle 138"/>
          <p:cNvSpPr>
            <a:spLocks noChangeArrowheads="1"/>
          </p:cNvSpPr>
          <p:nvPr/>
        </p:nvSpPr>
        <p:spPr bwMode="auto">
          <a:xfrm>
            <a:off x="2748258" y="4132263"/>
            <a:ext cx="366820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1200" b="1" dirty="0" smtClean="0">
                <a:solidFill>
                  <a:srgbClr val="0000FF"/>
                </a:solidFill>
                <a:cs typeface="Arial" charset="0"/>
              </a:rPr>
              <a:t>P5T1</a:t>
            </a:r>
            <a:endParaRPr lang="nl-NL" dirty="0">
              <a:cs typeface="Arial" charset="0"/>
            </a:endParaRPr>
          </a:p>
        </p:txBody>
      </p:sp>
      <p:sp>
        <p:nvSpPr>
          <p:cNvPr id="94" name="Rectangle 139"/>
          <p:cNvSpPr>
            <a:spLocks noChangeArrowheads="1"/>
          </p:cNvSpPr>
          <p:nvPr/>
        </p:nvSpPr>
        <p:spPr bwMode="auto">
          <a:xfrm>
            <a:off x="5844790" y="3690938"/>
            <a:ext cx="366820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1200" b="1" dirty="0" smtClean="0">
                <a:solidFill>
                  <a:srgbClr val="0000FF"/>
                </a:solidFill>
                <a:cs typeface="Arial" charset="0"/>
              </a:rPr>
              <a:t>P6T1</a:t>
            </a:r>
            <a:endParaRPr lang="nl-NL" dirty="0">
              <a:cs typeface="Arial" charset="0"/>
            </a:endParaRPr>
          </a:p>
        </p:txBody>
      </p:sp>
      <p:sp>
        <p:nvSpPr>
          <p:cNvPr id="95" name="Rectangle 140"/>
          <p:cNvSpPr>
            <a:spLocks noChangeArrowheads="1"/>
          </p:cNvSpPr>
          <p:nvPr/>
        </p:nvSpPr>
        <p:spPr bwMode="auto">
          <a:xfrm>
            <a:off x="4129787" y="3409951"/>
            <a:ext cx="714584" cy="57150"/>
          </a:xfrm>
          <a:prstGeom prst="rect">
            <a:avLst/>
          </a:prstGeom>
          <a:solidFill>
            <a:srgbClr val="33CC33"/>
          </a:solidFill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en-US">
              <a:latin typeface="Calibri" pitchFamily="34" charset="0"/>
            </a:endParaRPr>
          </a:p>
        </p:txBody>
      </p:sp>
      <p:sp>
        <p:nvSpPr>
          <p:cNvPr id="96" name="Rectangle 141"/>
          <p:cNvSpPr>
            <a:spLocks noChangeArrowheads="1"/>
          </p:cNvSpPr>
          <p:nvPr/>
        </p:nvSpPr>
        <p:spPr bwMode="auto">
          <a:xfrm>
            <a:off x="4129787" y="3409951"/>
            <a:ext cx="714584" cy="57150"/>
          </a:xfrm>
          <a:prstGeom prst="rect">
            <a:avLst/>
          </a:prstGeom>
          <a:noFill/>
          <a:ln w="4" cap="rnd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>
              <a:latin typeface="Calibri" pitchFamily="34" charset="0"/>
            </a:endParaRPr>
          </a:p>
        </p:txBody>
      </p:sp>
      <p:sp>
        <p:nvSpPr>
          <p:cNvPr id="97" name="Rectangle 143"/>
          <p:cNvSpPr>
            <a:spLocks noChangeArrowheads="1"/>
          </p:cNvSpPr>
          <p:nvPr/>
        </p:nvSpPr>
        <p:spPr bwMode="auto">
          <a:xfrm>
            <a:off x="3794727" y="3821113"/>
            <a:ext cx="674885" cy="49213"/>
          </a:xfrm>
          <a:prstGeom prst="rect">
            <a:avLst/>
          </a:prstGeom>
          <a:solidFill>
            <a:srgbClr val="33CC33"/>
          </a:solidFill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en-US">
              <a:latin typeface="Calibri" pitchFamily="34" charset="0"/>
            </a:endParaRPr>
          </a:p>
        </p:txBody>
      </p:sp>
      <p:sp>
        <p:nvSpPr>
          <p:cNvPr id="98" name="Rectangle 144"/>
          <p:cNvSpPr>
            <a:spLocks noChangeArrowheads="1"/>
          </p:cNvSpPr>
          <p:nvPr/>
        </p:nvSpPr>
        <p:spPr bwMode="auto">
          <a:xfrm>
            <a:off x="3758203" y="3819443"/>
            <a:ext cx="711409" cy="50884"/>
          </a:xfrm>
          <a:prstGeom prst="rect">
            <a:avLst/>
          </a:prstGeom>
          <a:noFill/>
          <a:ln w="4" cap="rnd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n-US">
              <a:latin typeface="Calibri" pitchFamily="34" charset="0"/>
            </a:endParaRPr>
          </a:p>
        </p:txBody>
      </p:sp>
      <p:sp>
        <p:nvSpPr>
          <p:cNvPr id="99" name="Freeform 146"/>
          <p:cNvSpPr>
            <a:spLocks noEditPoints="1"/>
          </p:cNvSpPr>
          <p:nvPr/>
        </p:nvSpPr>
        <p:spPr bwMode="auto">
          <a:xfrm>
            <a:off x="4185366" y="4084638"/>
            <a:ext cx="281070" cy="50800"/>
          </a:xfrm>
          <a:custGeom>
            <a:avLst/>
            <a:gdLst>
              <a:gd name="T0" fmla="*/ 174 w 2308"/>
              <a:gd name="T1" fmla="*/ 19 h 400"/>
              <a:gd name="T2" fmla="*/ 26 w 2308"/>
              <a:gd name="T3" fmla="*/ 19 h 400"/>
              <a:gd name="T4" fmla="*/ 23 w 2308"/>
              <a:gd name="T5" fmla="*/ 16 h 400"/>
              <a:gd name="T6" fmla="*/ 26 w 2308"/>
              <a:gd name="T7" fmla="*/ 13 h 400"/>
              <a:gd name="T8" fmla="*/ 174 w 2308"/>
              <a:gd name="T9" fmla="*/ 13 h 400"/>
              <a:gd name="T10" fmla="*/ 177 w 2308"/>
              <a:gd name="T11" fmla="*/ 16 h 400"/>
              <a:gd name="T12" fmla="*/ 174 w 2308"/>
              <a:gd name="T13" fmla="*/ 19 h 400"/>
              <a:gd name="T14" fmla="*/ 31 w 2308"/>
              <a:gd name="T15" fmla="*/ 32 h 400"/>
              <a:gd name="T16" fmla="*/ 0 w 2308"/>
              <a:gd name="T17" fmla="*/ 16 h 400"/>
              <a:gd name="T18" fmla="*/ 31 w 2308"/>
              <a:gd name="T19" fmla="*/ 0 h 400"/>
              <a:gd name="T20" fmla="*/ 31 w 2308"/>
              <a:gd name="T21" fmla="*/ 32 h 4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2308"/>
              <a:gd name="T34" fmla="*/ 0 h 400"/>
              <a:gd name="T35" fmla="*/ 2308 w 2308"/>
              <a:gd name="T36" fmla="*/ 400 h 4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2308" h="400">
                <a:moveTo>
                  <a:pt x="2275" y="233"/>
                </a:moveTo>
                <a:lnTo>
                  <a:pt x="333" y="233"/>
                </a:lnTo>
                <a:cubicBezTo>
                  <a:pt x="315" y="233"/>
                  <a:pt x="300" y="219"/>
                  <a:pt x="300" y="200"/>
                </a:cubicBezTo>
                <a:cubicBezTo>
                  <a:pt x="300" y="182"/>
                  <a:pt x="315" y="167"/>
                  <a:pt x="333" y="167"/>
                </a:cubicBezTo>
                <a:lnTo>
                  <a:pt x="2275" y="167"/>
                </a:lnTo>
                <a:cubicBezTo>
                  <a:pt x="2293" y="167"/>
                  <a:pt x="2308" y="182"/>
                  <a:pt x="2308" y="200"/>
                </a:cubicBezTo>
                <a:cubicBezTo>
                  <a:pt x="2308" y="219"/>
                  <a:pt x="2293" y="233"/>
                  <a:pt x="2275" y="233"/>
                </a:cubicBezTo>
                <a:close/>
                <a:moveTo>
                  <a:pt x="400" y="400"/>
                </a:moveTo>
                <a:lnTo>
                  <a:pt x="0" y="200"/>
                </a:lnTo>
                <a:lnTo>
                  <a:pt x="400" y="0"/>
                </a:lnTo>
                <a:lnTo>
                  <a:pt x="400" y="40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00" name="Freeform 147"/>
          <p:cNvSpPr>
            <a:spLocks noEditPoints="1"/>
          </p:cNvSpPr>
          <p:nvPr/>
        </p:nvSpPr>
        <p:spPr bwMode="auto">
          <a:xfrm>
            <a:off x="4144079" y="3659188"/>
            <a:ext cx="281070" cy="50800"/>
          </a:xfrm>
          <a:custGeom>
            <a:avLst/>
            <a:gdLst>
              <a:gd name="T0" fmla="*/ 3 w 2300"/>
              <a:gd name="T1" fmla="*/ 13 h 400"/>
              <a:gd name="T2" fmla="*/ 151 w 2300"/>
              <a:gd name="T3" fmla="*/ 13 h 400"/>
              <a:gd name="T4" fmla="*/ 154 w 2300"/>
              <a:gd name="T5" fmla="*/ 16 h 400"/>
              <a:gd name="T6" fmla="*/ 151 w 2300"/>
              <a:gd name="T7" fmla="*/ 19 h 400"/>
              <a:gd name="T8" fmla="*/ 3 w 2300"/>
              <a:gd name="T9" fmla="*/ 19 h 400"/>
              <a:gd name="T10" fmla="*/ 0 w 2300"/>
              <a:gd name="T11" fmla="*/ 16 h 400"/>
              <a:gd name="T12" fmla="*/ 3 w 2300"/>
              <a:gd name="T13" fmla="*/ 13 h 400"/>
              <a:gd name="T14" fmla="*/ 146 w 2300"/>
              <a:gd name="T15" fmla="*/ 0 h 400"/>
              <a:gd name="T16" fmla="*/ 177 w 2300"/>
              <a:gd name="T17" fmla="*/ 16 h 400"/>
              <a:gd name="T18" fmla="*/ 146 w 2300"/>
              <a:gd name="T19" fmla="*/ 32 h 400"/>
              <a:gd name="T20" fmla="*/ 146 w 2300"/>
              <a:gd name="T21" fmla="*/ 0 h 4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2300"/>
              <a:gd name="T34" fmla="*/ 0 h 400"/>
              <a:gd name="T35" fmla="*/ 2300 w 2300"/>
              <a:gd name="T36" fmla="*/ 400 h 4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2300" h="400">
                <a:moveTo>
                  <a:pt x="34" y="167"/>
                </a:moveTo>
                <a:lnTo>
                  <a:pt x="1967" y="167"/>
                </a:lnTo>
                <a:cubicBezTo>
                  <a:pt x="1986" y="167"/>
                  <a:pt x="2000" y="182"/>
                  <a:pt x="2000" y="200"/>
                </a:cubicBezTo>
                <a:cubicBezTo>
                  <a:pt x="2000" y="219"/>
                  <a:pt x="1986" y="234"/>
                  <a:pt x="1967" y="234"/>
                </a:cubicBezTo>
                <a:lnTo>
                  <a:pt x="34" y="234"/>
                </a:lnTo>
                <a:cubicBezTo>
                  <a:pt x="15" y="234"/>
                  <a:pt x="0" y="219"/>
                  <a:pt x="0" y="200"/>
                </a:cubicBezTo>
                <a:cubicBezTo>
                  <a:pt x="0" y="182"/>
                  <a:pt x="15" y="167"/>
                  <a:pt x="34" y="167"/>
                </a:cubicBezTo>
                <a:close/>
                <a:moveTo>
                  <a:pt x="1900" y="0"/>
                </a:moveTo>
                <a:lnTo>
                  <a:pt x="2300" y="200"/>
                </a:lnTo>
                <a:lnTo>
                  <a:pt x="1900" y="400"/>
                </a:lnTo>
                <a:lnTo>
                  <a:pt x="190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01" name="Rectangle 149"/>
          <p:cNvSpPr>
            <a:spLocks noChangeArrowheads="1"/>
          </p:cNvSpPr>
          <p:nvPr/>
        </p:nvSpPr>
        <p:spPr bwMode="auto">
          <a:xfrm>
            <a:off x="3532712" y="3336926"/>
            <a:ext cx="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endParaRPr lang="en-US">
              <a:cs typeface="Arial" charset="0"/>
            </a:endParaRPr>
          </a:p>
        </p:txBody>
      </p:sp>
      <p:sp>
        <p:nvSpPr>
          <p:cNvPr id="102" name="Freeform 150"/>
          <p:cNvSpPr>
            <a:spLocks noEditPoints="1"/>
          </p:cNvSpPr>
          <p:nvPr/>
        </p:nvSpPr>
        <p:spPr bwMode="auto">
          <a:xfrm>
            <a:off x="2511651" y="4619626"/>
            <a:ext cx="465274" cy="50800"/>
          </a:xfrm>
          <a:custGeom>
            <a:avLst/>
            <a:gdLst>
              <a:gd name="T0" fmla="*/ 3 w 3817"/>
              <a:gd name="T1" fmla="*/ 13 h 400"/>
              <a:gd name="T2" fmla="*/ 267 w 3817"/>
              <a:gd name="T3" fmla="*/ 13 h 400"/>
              <a:gd name="T4" fmla="*/ 270 w 3817"/>
              <a:gd name="T5" fmla="*/ 16 h 400"/>
              <a:gd name="T6" fmla="*/ 267 w 3817"/>
              <a:gd name="T7" fmla="*/ 19 h 400"/>
              <a:gd name="T8" fmla="*/ 3 w 3817"/>
              <a:gd name="T9" fmla="*/ 19 h 400"/>
              <a:gd name="T10" fmla="*/ 0 w 3817"/>
              <a:gd name="T11" fmla="*/ 16 h 400"/>
              <a:gd name="T12" fmla="*/ 3 w 3817"/>
              <a:gd name="T13" fmla="*/ 13 h 400"/>
              <a:gd name="T14" fmla="*/ 262 w 3817"/>
              <a:gd name="T15" fmla="*/ 0 h 400"/>
              <a:gd name="T16" fmla="*/ 293 w 3817"/>
              <a:gd name="T17" fmla="*/ 16 h 400"/>
              <a:gd name="T18" fmla="*/ 262 w 3817"/>
              <a:gd name="T19" fmla="*/ 32 h 400"/>
              <a:gd name="T20" fmla="*/ 262 w 3817"/>
              <a:gd name="T21" fmla="*/ 0 h 4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3817"/>
              <a:gd name="T34" fmla="*/ 0 h 400"/>
              <a:gd name="T35" fmla="*/ 3817 w 3817"/>
              <a:gd name="T36" fmla="*/ 400 h 4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3817" h="400">
                <a:moveTo>
                  <a:pt x="34" y="166"/>
                </a:moveTo>
                <a:lnTo>
                  <a:pt x="3484" y="166"/>
                </a:lnTo>
                <a:cubicBezTo>
                  <a:pt x="3502" y="166"/>
                  <a:pt x="3517" y="181"/>
                  <a:pt x="3517" y="200"/>
                </a:cubicBezTo>
                <a:cubicBezTo>
                  <a:pt x="3517" y="218"/>
                  <a:pt x="3502" y="233"/>
                  <a:pt x="3484" y="233"/>
                </a:cubicBezTo>
                <a:lnTo>
                  <a:pt x="34" y="233"/>
                </a:lnTo>
                <a:cubicBezTo>
                  <a:pt x="15" y="233"/>
                  <a:pt x="0" y="218"/>
                  <a:pt x="0" y="200"/>
                </a:cubicBezTo>
                <a:cubicBezTo>
                  <a:pt x="0" y="181"/>
                  <a:pt x="15" y="166"/>
                  <a:pt x="34" y="166"/>
                </a:cubicBezTo>
                <a:close/>
                <a:moveTo>
                  <a:pt x="3417" y="0"/>
                </a:moveTo>
                <a:lnTo>
                  <a:pt x="3817" y="200"/>
                </a:lnTo>
                <a:lnTo>
                  <a:pt x="3417" y="400"/>
                </a:lnTo>
                <a:lnTo>
                  <a:pt x="3417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03" name="Freeform 151"/>
          <p:cNvSpPr>
            <a:spLocks noEditPoints="1"/>
          </p:cNvSpPr>
          <p:nvPr/>
        </p:nvSpPr>
        <p:spPr bwMode="auto">
          <a:xfrm>
            <a:off x="4518839" y="4619626"/>
            <a:ext cx="182616" cy="50800"/>
          </a:xfrm>
          <a:custGeom>
            <a:avLst/>
            <a:gdLst>
              <a:gd name="T0" fmla="*/ 3 w 1492"/>
              <a:gd name="T1" fmla="*/ 13 h 400"/>
              <a:gd name="T2" fmla="*/ 89 w 1492"/>
              <a:gd name="T3" fmla="*/ 13 h 400"/>
              <a:gd name="T4" fmla="*/ 92 w 1492"/>
              <a:gd name="T5" fmla="*/ 16 h 400"/>
              <a:gd name="T6" fmla="*/ 89 w 1492"/>
              <a:gd name="T7" fmla="*/ 19 h 400"/>
              <a:gd name="T8" fmla="*/ 3 w 1492"/>
              <a:gd name="T9" fmla="*/ 19 h 400"/>
              <a:gd name="T10" fmla="*/ 0 w 1492"/>
              <a:gd name="T11" fmla="*/ 16 h 400"/>
              <a:gd name="T12" fmla="*/ 3 w 1492"/>
              <a:gd name="T13" fmla="*/ 13 h 400"/>
              <a:gd name="T14" fmla="*/ 84 w 1492"/>
              <a:gd name="T15" fmla="*/ 0 h 400"/>
              <a:gd name="T16" fmla="*/ 115 w 1492"/>
              <a:gd name="T17" fmla="*/ 16 h 400"/>
              <a:gd name="T18" fmla="*/ 84 w 1492"/>
              <a:gd name="T19" fmla="*/ 32 h 400"/>
              <a:gd name="T20" fmla="*/ 84 w 1492"/>
              <a:gd name="T21" fmla="*/ 0 h 4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1492"/>
              <a:gd name="T34" fmla="*/ 0 h 400"/>
              <a:gd name="T35" fmla="*/ 1492 w 1492"/>
              <a:gd name="T36" fmla="*/ 400 h 4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1492" h="400">
                <a:moveTo>
                  <a:pt x="34" y="166"/>
                </a:moveTo>
                <a:lnTo>
                  <a:pt x="1159" y="166"/>
                </a:lnTo>
                <a:cubicBezTo>
                  <a:pt x="1177" y="166"/>
                  <a:pt x="1192" y="181"/>
                  <a:pt x="1192" y="200"/>
                </a:cubicBezTo>
                <a:cubicBezTo>
                  <a:pt x="1192" y="218"/>
                  <a:pt x="1177" y="233"/>
                  <a:pt x="1159" y="233"/>
                </a:cubicBezTo>
                <a:lnTo>
                  <a:pt x="34" y="233"/>
                </a:lnTo>
                <a:cubicBezTo>
                  <a:pt x="15" y="233"/>
                  <a:pt x="0" y="218"/>
                  <a:pt x="0" y="200"/>
                </a:cubicBezTo>
                <a:cubicBezTo>
                  <a:pt x="0" y="181"/>
                  <a:pt x="15" y="166"/>
                  <a:pt x="34" y="166"/>
                </a:cubicBezTo>
                <a:close/>
                <a:moveTo>
                  <a:pt x="1092" y="0"/>
                </a:moveTo>
                <a:lnTo>
                  <a:pt x="1492" y="200"/>
                </a:lnTo>
                <a:lnTo>
                  <a:pt x="1092" y="400"/>
                </a:lnTo>
                <a:lnTo>
                  <a:pt x="1092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04" name="Freeform 152"/>
          <p:cNvSpPr>
            <a:spLocks noEditPoints="1"/>
          </p:cNvSpPr>
          <p:nvPr/>
        </p:nvSpPr>
        <p:spPr bwMode="auto">
          <a:xfrm>
            <a:off x="5620887" y="4619626"/>
            <a:ext cx="465274" cy="50800"/>
          </a:xfrm>
          <a:custGeom>
            <a:avLst/>
            <a:gdLst>
              <a:gd name="T0" fmla="*/ 290 w 1904"/>
              <a:gd name="T1" fmla="*/ 19 h 200"/>
              <a:gd name="T2" fmla="*/ 26 w 1904"/>
              <a:gd name="T3" fmla="*/ 19 h 200"/>
              <a:gd name="T4" fmla="*/ 23 w 1904"/>
              <a:gd name="T5" fmla="*/ 16 h 200"/>
              <a:gd name="T6" fmla="*/ 26 w 1904"/>
              <a:gd name="T7" fmla="*/ 13 h 200"/>
              <a:gd name="T8" fmla="*/ 290 w 1904"/>
              <a:gd name="T9" fmla="*/ 13 h 200"/>
              <a:gd name="T10" fmla="*/ 293 w 1904"/>
              <a:gd name="T11" fmla="*/ 16 h 200"/>
              <a:gd name="T12" fmla="*/ 290 w 1904"/>
              <a:gd name="T13" fmla="*/ 19 h 200"/>
              <a:gd name="T14" fmla="*/ 31 w 1904"/>
              <a:gd name="T15" fmla="*/ 32 h 200"/>
              <a:gd name="T16" fmla="*/ 0 w 1904"/>
              <a:gd name="T17" fmla="*/ 16 h 200"/>
              <a:gd name="T18" fmla="*/ 31 w 1904"/>
              <a:gd name="T19" fmla="*/ 0 h 200"/>
              <a:gd name="T20" fmla="*/ 31 w 1904"/>
              <a:gd name="T21" fmla="*/ 32 h 2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1904"/>
              <a:gd name="T34" fmla="*/ 0 h 200"/>
              <a:gd name="T35" fmla="*/ 1904 w 1904"/>
              <a:gd name="T36" fmla="*/ 200 h 2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1904" h="200">
                <a:moveTo>
                  <a:pt x="1887" y="117"/>
                </a:moveTo>
                <a:lnTo>
                  <a:pt x="167" y="117"/>
                </a:lnTo>
                <a:cubicBezTo>
                  <a:pt x="157" y="117"/>
                  <a:pt x="150" y="109"/>
                  <a:pt x="150" y="100"/>
                </a:cubicBezTo>
                <a:cubicBezTo>
                  <a:pt x="150" y="91"/>
                  <a:pt x="157" y="83"/>
                  <a:pt x="167" y="83"/>
                </a:cubicBezTo>
                <a:lnTo>
                  <a:pt x="1887" y="83"/>
                </a:lnTo>
                <a:cubicBezTo>
                  <a:pt x="1897" y="83"/>
                  <a:pt x="1904" y="91"/>
                  <a:pt x="1904" y="100"/>
                </a:cubicBezTo>
                <a:cubicBezTo>
                  <a:pt x="1904" y="109"/>
                  <a:pt x="1897" y="117"/>
                  <a:pt x="1887" y="117"/>
                </a:cubicBezTo>
                <a:close/>
                <a:moveTo>
                  <a:pt x="200" y="200"/>
                </a:moveTo>
                <a:lnTo>
                  <a:pt x="0" y="100"/>
                </a:lnTo>
                <a:lnTo>
                  <a:pt x="200" y="0"/>
                </a:lnTo>
                <a:lnTo>
                  <a:pt x="200" y="20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US"/>
          </a:p>
        </p:txBody>
      </p:sp>
      <p:grpSp>
        <p:nvGrpSpPr>
          <p:cNvPr id="105" name="Group 155"/>
          <p:cNvGrpSpPr>
            <a:grpSpLocks/>
          </p:cNvGrpSpPr>
          <p:nvPr/>
        </p:nvGrpSpPr>
        <p:grpSpPr bwMode="auto">
          <a:xfrm>
            <a:off x="4726862" y="4738688"/>
            <a:ext cx="1310071" cy="47625"/>
            <a:chOff x="2947" y="2942"/>
            <a:chExt cx="825" cy="30"/>
          </a:xfrm>
        </p:grpSpPr>
        <p:sp>
          <p:nvSpPr>
            <p:cNvPr id="106" name="Rectangle 153"/>
            <p:cNvSpPr>
              <a:spLocks noChangeArrowheads="1"/>
            </p:cNvSpPr>
            <p:nvPr/>
          </p:nvSpPr>
          <p:spPr bwMode="auto">
            <a:xfrm>
              <a:off x="2947" y="2942"/>
              <a:ext cx="825" cy="3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  <p:sp>
          <p:nvSpPr>
            <p:cNvPr id="107" name="Rectangle 154"/>
            <p:cNvSpPr>
              <a:spLocks noChangeArrowheads="1"/>
            </p:cNvSpPr>
            <p:nvPr/>
          </p:nvSpPr>
          <p:spPr bwMode="auto">
            <a:xfrm>
              <a:off x="2947" y="2942"/>
              <a:ext cx="825" cy="30"/>
            </a:xfrm>
            <a:prstGeom prst="rect">
              <a:avLst/>
            </a:prstGeom>
            <a:noFill/>
            <a:ln w="4" cap="rnd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</p:grpSp>
      <p:sp>
        <p:nvSpPr>
          <p:cNvPr id="108" name="Freeform 156"/>
          <p:cNvSpPr>
            <a:spLocks/>
          </p:cNvSpPr>
          <p:nvPr/>
        </p:nvSpPr>
        <p:spPr bwMode="auto">
          <a:xfrm>
            <a:off x="4555362" y="4849813"/>
            <a:ext cx="1452988" cy="103188"/>
          </a:xfrm>
          <a:custGeom>
            <a:avLst/>
            <a:gdLst>
              <a:gd name="T0" fmla="*/ 915 w 5950"/>
              <a:gd name="T1" fmla="*/ 0 h 413"/>
              <a:gd name="T2" fmla="*/ 839 w 5950"/>
              <a:gd name="T3" fmla="*/ 32 h 413"/>
              <a:gd name="T4" fmla="*/ 534 w 5950"/>
              <a:gd name="T5" fmla="*/ 32 h 413"/>
              <a:gd name="T6" fmla="*/ 458 w 5950"/>
              <a:gd name="T7" fmla="*/ 65 h 413"/>
              <a:gd name="T8" fmla="*/ 381 w 5950"/>
              <a:gd name="T9" fmla="*/ 32 h 413"/>
              <a:gd name="T10" fmla="*/ 76 w 5950"/>
              <a:gd name="T11" fmla="*/ 32 h 413"/>
              <a:gd name="T12" fmla="*/ 0 w 5950"/>
              <a:gd name="T13" fmla="*/ 0 h 413"/>
              <a:gd name="T14" fmla="*/ 0 60000 65536"/>
              <a:gd name="T15" fmla="*/ 0 60000 65536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w 5950"/>
              <a:gd name="T22" fmla="*/ 0 h 413"/>
              <a:gd name="T23" fmla="*/ 5950 w 5950"/>
              <a:gd name="T24" fmla="*/ 413 h 413"/>
            </a:gdLst>
            <a:ahLst/>
            <a:cxnLst>
              <a:cxn ang="T14">
                <a:pos x="T0" y="T1"/>
              </a:cxn>
              <a:cxn ang="T15">
                <a:pos x="T2" y="T3"/>
              </a:cxn>
              <a:cxn ang="T16">
                <a:pos x="T4" y="T5"/>
              </a:cxn>
              <a:cxn ang="T17">
                <a:pos x="T6" y="T7"/>
              </a:cxn>
              <a:cxn ang="T18">
                <a:pos x="T8" y="T9"/>
              </a:cxn>
              <a:cxn ang="T19">
                <a:pos x="T10" y="T11"/>
              </a:cxn>
              <a:cxn ang="T20">
                <a:pos x="T12" y="T13"/>
              </a:cxn>
            </a:cxnLst>
            <a:rect l="T21" t="T22" r="T23" b="T24"/>
            <a:pathLst>
              <a:path w="5950" h="413">
                <a:moveTo>
                  <a:pt x="5950" y="0"/>
                </a:moveTo>
                <a:cubicBezTo>
                  <a:pt x="5950" y="114"/>
                  <a:pt x="5728" y="206"/>
                  <a:pt x="5455" y="206"/>
                </a:cubicBezTo>
                <a:lnTo>
                  <a:pt x="3471" y="206"/>
                </a:lnTo>
                <a:cubicBezTo>
                  <a:pt x="3197" y="206"/>
                  <a:pt x="2975" y="299"/>
                  <a:pt x="2975" y="413"/>
                </a:cubicBezTo>
                <a:cubicBezTo>
                  <a:pt x="2975" y="299"/>
                  <a:pt x="2753" y="206"/>
                  <a:pt x="2480" y="206"/>
                </a:cubicBezTo>
                <a:lnTo>
                  <a:pt x="496" y="206"/>
                </a:lnTo>
                <a:cubicBezTo>
                  <a:pt x="222" y="206"/>
                  <a:pt x="0" y="114"/>
                  <a:pt x="0" y="0"/>
                </a:cubicBezTo>
              </a:path>
            </a:pathLst>
          </a:custGeom>
          <a:noFill/>
          <a:ln w="4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09" name="Line 159"/>
          <p:cNvSpPr>
            <a:spLocks noChangeShapeType="1"/>
          </p:cNvSpPr>
          <p:nvPr/>
        </p:nvSpPr>
        <p:spPr bwMode="auto">
          <a:xfrm flipH="1" flipV="1">
            <a:off x="2316331" y="4549776"/>
            <a:ext cx="184204" cy="95250"/>
          </a:xfrm>
          <a:prstGeom prst="line">
            <a:avLst/>
          </a:prstGeom>
          <a:noFill/>
          <a:ln w="4" cap="rnd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10" name="Line 160"/>
          <p:cNvSpPr>
            <a:spLocks noChangeShapeType="1"/>
          </p:cNvSpPr>
          <p:nvPr/>
        </p:nvSpPr>
        <p:spPr bwMode="auto">
          <a:xfrm flipV="1">
            <a:off x="6090924" y="4549776"/>
            <a:ext cx="184204" cy="95250"/>
          </a:xfrm>
          <a:prstGeom prst="line">
            <a:avLst/>
          </a:prstGeom>
          <a:noFill/>
          <a:ln w="4" cap="rnd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grpSp>
        <p:nvGrpSpPr>
          <p:cNvPr id="111" name="Group 163"/>
          <p:cNvGrpSpPr>
            <a:grpSpLocks/>
          </p:cNvGrpSpPr>
          <p:nvPr/>
        </p:nvGrpSpPr>
        <p:grpSpPr bwMode="auto">
          <a:xfrm>
            <a:off x="4541070" y="4740276"/>
            <a:ext cx="184204" cy="46038"/>
            <a:chOff x="2830" y="2943"/>
            <a:chExt cx="116" cy="29"/>
          </a:xfrm>
        </p:grpSpPr>
        <p:sp>
          <p:nvSpPr>
            <p:cNvPr id="112" name="Rectangle 161"/>
            <p:cNvSpPr>
              <a:spLocks noChangeArrowheads="1"/>
            </p:cNvSpPr>
            <p:nvPr/>
          </p:nvSpPr>
          <p:spPr bwMode="auto">
            <a:xfrm>
              <a:off x="2830" y="2943"/>
              <a:ext cx="116" cy="29"/>
            </a:xfrm>
            <a:prstGeom prst="rect">
              <a:avLst/>
            </a:prstGeom>
            <a:solidFill>
              <a:srgbClr val="33CC33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  <p:sp>
          <p:nvSpPr>
            <p:cNvPr id="113" name="Rectangle 162"/>
            <p:cNvSpPr>
              <a:spLocks noChangeArrowheads="1"/>
            </p:cNvSpPr>
            <p:nvPr/>
          </p:nvSpPr>
          <p:spPr bwMode="auto">
            <a:xfrm>
              <a:off x="2830" y="2943"/>
              <a:ext cx="116" cy="29"/>
            </a:xfrm>
            <a:prstGeom prst="rect">
              <a:avLst/>
            </a:prstGeom>
            <a:noFill/>
            <a:ln w="4" cap="rnd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</p:grpSp>
      <p:grpSp>
        <p:nvGrpSpPr>
          <p:cNvPr id="114" name="Group 167"/>
          <p:cNvGrpSpPr>
            <a:grpSpLocks/>
          </p:cNvGrpSpPr>
          <p:nvPr/>
        </p:nvGrpSpPr>
        <p:grpSpPr bwMode="auto">
          <a:xfrm>
            <a:off x="2479891" y="4732338"/>
            <a:ext cx="1310071" cy="47625"/>
            <a:chOff x="1532" y="2938"/>
            <a:chExt cx="825" cy="30"/>
          </a:xfrm>
        </p:grpSpPr>
        <p:sp>
          <p:nvSpPr>
            <p:cNvPr id="115" name="Rectangle 165"/>
            <p:cNvSpPr>
              <a:spLocks noChangeArrowheads="1"/>
            </p:cNvSpPr>
            <p:nvPr/>
          </p:nvSpPr>
          <p:spPr bwMode="auto">
            <a:xfrm>
              <a:off x="1532" y="2938"/>
              <a:ext cx="825" cy="3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  <p:sp>
          <p:nvSpPr>
            <p:cNvPr id="116" name="Rectangle 166"/>
            <p:cNvSpPr>
              <a:spLocks noChangeArrowheads="1"/>
            </p:cNvSpPr>
            <p:nvPr/>
          </p:nvSpPr>
          <p:spPr bwMode="auto">
            <a:xfrm>
              <a:off x="1532" y="2938"/>
              <a:ext cx="825" cy="30"/>
            </a:xfrm>
            <a:prstGeom prst="rect">
              <a:avLst/>
            </a:prstGeom>
            <a:noFill/>
            <a:ln w="4" cap="rnd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</p:grpSp>
      <p:grpSp>
        <p:nvGrpSpPr>
          <p:cNvPr id="117" name="Group 170"/>
          <p:cNvGrpSpPr>
            <a:grpSpLocks/>
          </p:cNvGrpSpPr>
          <p:nvPr/>
        </p:nvGrpSpPr>
        <p:grpSpPr bwMode="auto">
          <a:xfrm>
            <a:off x="3788375" y="4735513"/>
            <a:ext cx="184204" cy="46038"/>
            <a:chOff x="2356" y="2940"/>
            <a:chExt cx="116" cy="29"/>
          </a:xfrm>
        </p:grpSpPr>
        <p:sp>
          <p:nvSpPr>
            <p:cNvPr id="118" name="Rectangle 168"/>
            <p:cNvSpPr>
              <a:spLocks noChangeArrowheads="1"/>
            </p:cNvSpPr>
            <p:nvPr/>
          </p:nvSpPr>
          <p:spPr bwMode="auto">
            <a:xfrm>
              <a:off x="2356" y="2940"/>
              <a:ext cx="116" cy="29"/>
            </a:xfrm>
            <a:prstGeom prst="rect">
              <a:avLst/>
            </a:prstGeom>
            <a:solidFill>
              <a:srgbClr val="33CC33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  <p:sp>
          <p:nvSpPr>
            <p:cNvPr id="119" name="Rectangle 169"/>
            <p:cNvSpPr>
              <a:spLocks noChangeArrowheads="1"/>
            </p:cNvSpPr>
            <p:nvPr/>
          </p:nvSpPr>
          <p:spPr bwMode="auto">
            <a:xfrm>
              <a:off x="2356" y="2940"/>
              <a:ext cx="116" cy="29"/>
            </a:xfrm>
            <a:prstGeom prst="rect">
              <a:avLst/>
            </a:prstGeom>
            <a:noFill/>
            <a:ln w="4" cap="rnd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</p:grpSp>
      <p:sp>
        <p:nvSpPr>
          <p:cNvPr id="120" name="Freeform 171"/>
          <p:cNvSpPr>
            <a:spLocks/>
          </p:cNvSpPr>
          <p:nvPr/>
        </p:nvSpPr>
        <p:spPr bwMode="auto">
          <a:xfrm>
            <a:off x="2498947" y="4854576"/>
            <a:ext cx="1452988" cy="103188"/>
          </a:xfrm>
          <a:custGeom>
            <a:avLst/>
            <a:gdLst>
              <a:gd name="T0" fmla="*/ 915 w 11900"/>
              <a:gd name="T1" fmla="*/ 0 h 825"/>
              <a:gd name="T2" fmla="*/ 839 w 11900"/>
              <a:gd name="T3" fmla="*/ 33 h 825"/>
              <a:gd name="T4" fmla="*/ 534 w 11900"/>
              <a:gd name="T5" fmla="*/ 33 h 825"/>
              <a:gd name="T6" fmla="*/ 458 w 11900"/>
              <a:gd name="T7" fmla="*/ 65 h 825"/>
              <a:gd name="T8" fmla="*/ 381 w 11900"/>
              <a:gd name="T9" fmla="*/ 33 h 825"/>
              <a:gd name="T10" fmla="*/ 76 w 11900"/>
              <a:gd name="T11" fmla="*/ 33 h 825"/>
              <a:gd name="T12" fmla="*/ 0 w 11900"/>
              <a:gd name="T13" fmla="*/ 0 h 825"/>
              <a:gd name="T14" fmla="*/ 0 60000 65536"/>
              <a:gd name="T15" fmla="*/ 0 60000 65536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w 11900"/>
              <a:gd name="T22" fmla="*/ 0 h 825"/>
              <a:gd name="T23" fmla="*/ 11900 w 11900"/>
              <a:gd name="T24" fmla="*/ 825 h 825"/>
            </a:gdLst>
            <a:ahLst/>
            <a:cxnLst>
              <a:cxn ang="T14">
                <a:pos x="T0" y="T1"/>
              </a:cxn>
              <a:cxn ang="T15">
                <a:pos x="T2" y="T3"/>
              </a:cxn>
              <a:cxn ang="T16">
                <a:pos x="T4" y="T5"/>
              </a:cxn>
              <a:cxn ang="T17">
                <a:pos x="T6" y="T7"/>
              </a:cxn>
              <a:cxn ang="T18">
                <a:pos x="T8" y="T9"/>
              </a:cxn>
              <a:cxn ang="T19">
                <a:pos x="T10" y="T11"/>
              </a:cxn>
              <a:cxn ang="T20">
                <a:pos x="T12" y="T13"/>
              </a:cxn>
            </a:cxnLst>
            <a:rect l="T21" t="T22" r="T23" b="T24"/>
            <a:pathLst>
              <a:path w="11900" h="825">
                <a:moveTo>
                  <a:pt x="11900" y="0"/>
                </a:moveTo>
                <a:cubicBezTo>
                  <a:pt x="11900" y="228"/>
                  <a:pt x="11456" y="413"/>
                  <a:pt x="10909" y="413"/>
                </a:cubicBezTo>
                <a:lnTo>
                  <a:pt x="6942" y="413"/>
                </a:lnTo>
                <a:cubicBezTo>
                  <a:pt x="6395" y="413"/>
                  <a:pt x="5950" y="597"/>
                  <a:pt x="5950" y="825"/>
                </a:cubicBezTo>
                <a:cubicBezTo>
                  <a:pt x="5950" y="597"/>
                  <a:pt x="5506" y="413"/>
                  <a:pt x="4959" y="413"/>
                </a:cubicBezTo>
                <a:lnTo>
                  <a:pt x="992" y="413"/>
                </a:lnTo>
                <a:cubicBezTo>
                  <a:pt x="445" y="413"/>
                  <a:pt x="0" y="228"/>
                  <a:pt x="0" y="0"/>
                </a:cubicBezTo>
              </a:path>
            </a:pathLst>
          </a:custGeom>
          <a:noFill/>
          <a:ln w="4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21" name="Freeform 177"/>
          <p:cNvSpPr>
            <a:spLocks noEditPoints="1"/>
          </p:cNvSpPr>
          <p:nvPr/>
        </p:nvSpPr>
        <p:spPr bwMode="auto">
          <a:xfrm>
            <a:off x="4518839" y="4619626"/>
            <a:ext cx="182616" cy="50800"/>
          </a:xfrm>
          <a:custGeom>
            <a:avLst/>
            <a:gdLst>
              <a:gd name="T0" fmla="*/ 3 w 1492"/>
              <a:gd name="T1" fmla="*/ 13 h 400"/>
              <a:gd name="T2" fmla="*/ 89 w 1492"/>
              <a:gd name="T3" fmla="*/ 13 h 400"/>
              <a:gd name="T4" fmla="*/ 92 w 1492"/>
              <a:gd name="T5" fmla="*/ 16 h 400"/>
              <a:gd name="T6" fmla="*/ 89 w 1492"/>
              <a:gd name="T7" fmla="*/ 19 h 400"/>
              <a:gd name="T8" fmla="*/ 3 w 1492"/>
              <a:gd name="T9" fmla="*/ 19 h 400"/>
              <a:gd name="T10" fmla="*/ 0 w 1492"/>
              <a:gd name="T11" fmla="*/ 16 h 400"/>
              <a:gd name="T12" fmla="*/ 3 w 1492"/>
              <a:gd name="T13" fmla="*/ 13 h 400"/>
              <a:gd name="T14" fmla="*/ 84 w 1492"/>
              <a:gd name="T15" fmla="*/ 0 h 400"/>
              <a:gd name="T16" fmla="*/ 115 w 1492"/>
              <a:gd name="T17" fmla="*/ 16 h 400"/>
              <a:gd name="T18" fmla="*/ 84 w 1492"/>
              <a:gd name="T19" fmla="*/ 32 h 400"/>
              <a:gd name="T20" fmla="*/ 84 w 1492"/>
              <a:gd name="T21" fmla="*/ 0 h 4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1492"/>
              <a:gd name="T34" fmla="*/ 0 h 400"/>
              <a:gd name="T35" fmla="*/ 1492 w 1492"/>
              <a:gd name="T36" fmla="*/ 400 h 4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1492" h="400">
                <a:moveTo>
                  <a:pt x="34" y="166"/>
                </a:moveTo>
                <a:lnTo>
                  <a:pt x="1159" y="166"/>
                </a:lnTo>
                <a:cubicBezTo>
                  <a:pt x="1177" y="166"/>
                  <a:pt x="1192" y="181"/>
                  <a:pt x="1192" y="200"/>
                </a:cubicBezTo>
                <a:cubicBezTo>
                  <a:pt x="1192" y="218"/>
                  <a:pt x="1177" y="233"/>
                  <a:pt x="1159" y="233"/>
                </a:cubicBezTo>
                <a:lnTo>
                  <a:pt x="34" y="233"/>
                </a:lnTo>
                <a:cubicBezTo>
                  <a:pt x="15" y="233"/>
                  <a:pt x="0" y="218"/>
                  <a:pt x="0" y="200"/>
                </a:cubicBezTo>
                <a:cubicBezTo>
                  <a:pt x="0" y="181"/>
                  <a:pt x="15" y="166"/>
                  <a:pt x="34" y="166"/>
                </a:cubicBezTo>
                <a:close/>
                <a:moveTo>
                  <a:pt x="1092" y="0"/>
                </a:moveTo>
                <a:lnTo>
                  <a:pt x="1492" y="200"/>
                </a:lnTo>
                <a:lnTo>
                  <a:pt x="1092" y="400"/>
                </a:lnTo>
                <a:lnTo>
                  <a:pt x="1092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22" name="Freeform 178"/>
          <p:cNvSpPr>
            <a:spLocks noEditPoints="1"/>
          </p:cNvSpPr>
          <p:nvPr/>
        </p:nvSpPr>
        <p:spPr bwMode="auto">
          <a:xfrm>
            <a:off x="5620887" y="4619626"/>
            <a:ext cx="465274" cy="50800"/>
          </a:xfrm>
          <a:custGeom>
            <a:avLst/>
            <a:gdLst>
              <a:gd name="T0" fmla="*/ 290 w 1904"/>
              <a:gd name="T1" fmla="*/ 19 h 200"/>
              <a:gd name="T2" fmla="*/ 26 w 1904"/>
              <a:gd name="T3" fmla="*/ 19 h 200"/>
              <a:gd name="T4" fmla="*/ 23 w 1904"/>
              <a:gd name="T5" fmla="*/ 16 h 200"/>
              <a:gd name="T6" fmla="*/ 26 w 1904"/>
              <a:gd name="T7" fmla="*/ 13 h 200"/>
              <a:gd name="T8" fmla="*/ 290 w 1904"/>
              <a:gd name="T9" fmla="*/ 13 h 200"/>
              <a:gd name="T10" fmla="*/ 293 w 1904"/>
              <a:gd name="T11" fmla="*/ 16 h 200"/>
              <a:gd name="T12" fmla="*/ 290 w 1904"/>
              <a:gd name="T13" fmla="*/ 19 h 200"/>
              <a:gd name="T14" fmla="*/ 31 w 1904"/>
              <a:gd name="T15" fmla="*/ 32 h 200"/>
              <a:gd name="T16" fmla="*/ 0 w 1904"/>
              <a:gd name="T17" fmla="*/ 16 h 200"/>
              <a:gd name="T18" fmla="*/ 31 w 1904"/>
              <a:gd name="T19" fmla="*/ 0 h 200"/>
              <a:gd name="T20" fmla="*/ 31 w 1904"/>
              <a:gd name="T21" fmla="*/ 32 h 2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1904"/>
              <a:gd name="T34" fmla="*/ 0 h 200"/>
              <a:gd name="T35" fmla="*/ 1904 w 1904"/>
              <a:gd name="T36" fmla="*/ 200 h 2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1904" h="200">
                <a:moveTo>
                  <a:pt x="1887" y="117"/>
                </a:moveTo>
                <a:lnTo>
                  <a:pt x="167" y="117"/>
                </a:lnTo>
                <a:cubicBezTo>
                  <a:pt x="157" y="117"/>
                  <a:pt x="150" y="109"/>
                  <a:pt x="150" y="100"/>
                </a:cubicBezTo>
                <a:cubicBezTo>
                  <a:pt x="150" y="91"/>
                  <a:pt x="157" y="83"/>
                  <a:pt x="167" y="83"/>
                </a:cubicBezTo>
                <a:lnTo>
                  <a:pt x="1887" y="83"/>
                </a:lnTo>
                <a:cubicBezTo>
                  <a:pt x="1897" y="83"/>
                  <a:pt x="1904" y="91"/>
                  <a:pt x="1904" y="100"/>
                </a:cubicBezTo>
                <a:cubicBezTo>
                  <a:pt x="1904" y="109"/>
                  <a:pt x="1897" y="117"/>
                  <a:pt x="1887" y="117"/>
                </a:cubicBezTo>
                <a:close/>
                <a:moveTo>
                  <a:pt x="200" y="200"/>
                </a:moveTo>
                <a:lnTo>
                  <a:pt x="0" y="100"/>
                </a:lnTo>
                <a:lnTo>
                  <a:pt x="200" y="0"/>
                </a:lnTo>
                <a:lnTo>
                  <a:pt x="200" y="20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US"/>
          </a:p>
        </p:txBody>
      </p:sp>
      <p:grpSp>
        <p:nvGrpSpPr>
          <p:cNvPr id="123" name="Group 181"/>
          <p:cNvGrpSpPr>
            <a:grpSpLocks/>
          </p:cNvGrpSpPr>
          <p:nvPr/>
        </p:nvGrpSpPr>
        <p:grpSpPr bwMode="auto">
          <a:xfrm>
            <a:off x="4726862" y="4738688"/>
            <a:ext cx="1310071" cy="47625"/>
            <a:chOff x="2947" y="2942"/>
            <a:chExt cx="825" cy="30"/>
          </a:xfrm>
        </p:grpSpPr>
        <p:sp>
          <p:nvSpPr>
            <p:cNvPr id="124" name="Rectangle 179"/>
            <p:cNvSpPr>
              <a:spLocks noChangeArrowheads="1"/>
            </p:cNvSpPr>
            <p:nvPr/>
          </p:nvSpPr>
          <p:spPr bwMode="auto">
            <a:xfrm>
              <a:off x="2947" y="2942"/>
              <a:ext cx="825" cy="3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  <p:sp>
          <p:nvSpPr>
            <p:cNvPr id="125" name="Rectangle 180"/>
            <p:cNvSpPr>
              <a:spLocks noChangeArrowheads="1"/>
            </p:cNvSpPr>
            <p:nvPr/>
          </p:nvSpPr>
          <p:spPr bwMode="auto">
            <a:xfrm>
              <a:off x="2947" y="2942"/>
              <a:ext cx="825" cy="30"/>
            </a:xfrm>
            <a:prstGeom prst="rect">
              <a:avLst/>
            </a:prstGeom>
            <a:noFill/>
            <a:ln w="4" cap="rnd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</p:grpSp>
      <p:sp>
        <p:nvSpPr>
          <p:cNvPr id="126" name="Freeform 182"/>
          <p:cNvSpPr>
            <a:spLocks/>
          </p:cNvSpPr>
          <p:nvPr/>
        </p:nvSpPr>
        <p:spPr bwMode="auto">
          <a:xfrm>
            <a:off x="4555362" y="4849813"/>
            <a:ext cx="1452988" cy="103188"/>
          </a:xfrm>
          <a:custGeom>
            <a:avLst/>
            <a:gdLst>
              <a:gd name="T0" fmla="*/ 915 w 5950"/>
              <a:gd name="T1" fmla="*/ 0 h 413"/>
              <a:gd name="T2" fmla="*/ 839 w 5950"/>
              <a:gd name="T3" fmla="*/ 32 h 413"/>
              <a:gd name="T4" fmla="*/ 534 w 5950"/>
              <a:gd name="T5" fmla="*/ 32 h 413"/>
              <a:gd name="T6" fmla="*/ 458 w 5950"/>
              <a:gd name="T7" fmla="*/ 65 h 413"/>
              <a:gd name="T8" fmla="*/ 381 w 5950"/>
              <a:gd name="T9" fmla="*/ 32 h 413"/>
              <a:gd name="T10" fmla="*/ 76 w 5950"/>
              <a:gd name="T11" fmla="*/ 32 h 413"/>
              <a:gd name="T12" fmla="*/ 0 w 5950"/>
              <a:gd name="T13" fmla="*/ 0 h 413"/>
              <a:gd name="T14" fmla="*/ 0 60000 65536"/>
              <a:gd name="T15" fmla="*/ 0 60000 65536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w 5950"/>
              <a:gd name="T22" fmla="*/ 0 h 413"/>
              <a:gd name="T23" fmla="*/ 5950 w 5950"/>
              <a:gd name="T24" fmla="*/ 413 h 413"/>
            </a:gdLst>
            <a:ahLst/>
            <a:cxnLst>
              <a:cxn ang="T14">
                <a:pos x="T0" y="T1"/>
              </a:cxn>
              <a:cxn ang="T15">
                <a:pos x="T2" y="T3"/>
              </a:cxn>
              <a:cxn ang="T16">
                <a:pos x="T4" y="T5"/>
              </a:cxn>
              <a:cxn ang="T17">
                <a:pos x="T6" y="T7"/>
              </a:cxn>
              <a:cxn ang="T18">
                <a:pos x="T8" y="T9"/>
              </a:cxn>
              <a:cxn ang="T19">
                <a:pos x="T10" y="T11"/>
              </a:cxn>
              <a:cxn ang="T20">
                <a:pos x="T12" y="T13"/>
              </a:cxn>
            </a:cxnLst>
            <a:rect l="T21" t="T22" r="T23" b="T24"/>
            <a:pathLst>
              <a:path w="5950" h="413">
                <a:moveTo>
                  <a:pt x="5950" y="0"/>
                </a:moveTo>
                <a:cubicBezTo>
                  <a:pt x="5950" y="114"/>
                  <a:pt x="5728" y="206"/>
                  <a:pt x="5455" y="206"/>
                </a:cubicBezTo>
                <a:lnTo>
                  <a:pt x="3471" y="206"/>
                </a:lnTo>
                <a:cubicBezTo>
                  <a:pt x="3197" y="206"/>
                  <a:pt x="2975" y="299"/>
                  <a:pt x="2975" y="413"/>
                </a:cubicBezTo>
                <a:cubicBezTo>
                  <a:pt x="2975" y="299"/>
                  <a:pt x="2753" y="206"/>
                  <a:pt x="2480" y="206"/>
                </a:cubicBezTo>
                <a:lnTo>
                  <a:pt x="496" y="206"/>
                </a:lnTo>
                <a:cubicBezTo>
                  <a:pt x="222" y="206"/>
                  <a:pt x="0" y="114"/>
                  <a:pt x="0" y="0"/>
                </a:cubicBezTo>
              </a:path>
            </a:pathLst>
          </a:custGeom>
          <a:noFill/>
          <a:ln w="4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27" name="Rectangle 183"/>
          <p:cNvSpPr>
            <a:spLocks noChangeArrowheads="1"/>
          </p:cNvSpPr>
          <p:nvPr/>
        </p:nvSpPr>
        <p:spPr bwMode="auto">
          <a:xfrm>
            <a:off x="2524354" y="4445001"/>
            <a:ext cx="366820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1200" b="1" dirty="0">
                <a:solidFill>
                  <a:srgbClr val="0000FF"/>
                </a:solidFill>
                <a:cs typeface="Arial" charset="0"/>
              </a:rPr>
              <a:t>P1T1</a:t>
            </a:r>
            <a:endParaRPr lang="nl-NL" dirty="0">
              <a:cs typeface="Arial" charset="0"/>
            </a:endParaRPr>
          </a:p>
        </p:txBody>
      </p:sp>
      <p:sp>
        <p:nvSpPr>
          <p:cNvPr id="128" name="Line 185"/>
          <p:cNvSpPr>
            <a:spLocks noChangeShapeType="1"/>
          </p:cNvSpPr>
          <p:nvPr/>
        </p:nvSpPr>
        <p:spPr bwMode="auto">
          <a:xfrm flipH="1" flipV="1">
            <a:off x="2316331" y="4549776"/>
            <a:ext cx="184204" cy="95250"/>
          </a:xfrm>
          <a:prstGeom prst="line">
            <a:avLst/>
          </a:prstGeom>
          <a:noFill/>
          <a:ln w="4" cap="rnd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29" name="Line 186"/>
          <p:cNvSpPr>
            <a:spLocks noChangeShapeType="1"/>
          </p:cNvSpPr>
          <p:nvPr/>
        </p:nvSpPr>
        <p:spPr bwMode="auto">
          <a:xfrm flipV="1">
            <a:off x="6090924" y="4549776"/>
            <a:ext cx="184204" cy="95250"/>
          </a:xfrm>
          <a:prstGeom prst="line">
            <a:avLst/>
          </a:prstGeom>
          <a:noFill/>
          <a:ln w="4" cap="rnd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grpSp>
        <p:nvGrpSpPr>
          <p:cNvPr id="130" name="Group 189"/>
          <p:cNvGrpSpPr>
            <a:grpSpLocks/>
          </p:cNvGrpSpPr>
          <p:nvPr/>
        </p:nvGrpSpPr>
        <p:grpSpPr bwMode="auto">
          <a:xfrm>
            <a:off x="4541070" y="4740276"/>
            <a:ext cx="184204" cy="46038"/>
            <a:chOff x="2830" y="2943"/>
            <a:chExt cx="116" cy="29"/>
          </a:xfrm>
        </p:grpSpPr>
        <p:sp>
          <p:nvSpPr>
            <p:cNvPr id="131" name="Rectangle 187"/>
            <p:cNvSpPr>
              <a:spLocks noChangeArrowheads="1"/>
            </p:cNvSpPr>
            <p:nvPr/>
          </p:nvSpPr>
          <p:spPr bwMode="auto">
            <a:xfrm>
              <a:off x="2830" y="2943"/>
              <a:ext cx="116" cy="29"/>
            </a:xfrm>
            <a:prstGeom prst="rect">
              <a:avLst/>
            </a:prstGeom>
            <a:solidFill>
              <a:srgbClr val="33CC33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  <p:sp>
          <p:nvSpPr>
            <p:cNvPr id="132" name="Rectangle 188"/>
            <p:cNvSpPr>
              <a:spLocks noChangeArrowheads="1"/>
            </p:cNvSpPr>
            <p:nvPr/>
          </p:nvSpPr>
          <p:spPr bwMode="auto">
            <a:xfrm>
              <a:off x="2830" y="2943"/>
              <a:ext cx="116" cy="29"/>
            </a:xfrm>
            <a:prstGeom prst="rect">
              <a:avLst/>
            </a:prstGeom>
            <a:noFill/>
            <a:ln w="4" cap="rnd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</p:grpSp>
      <p:grpSp>
        <p:nvGrpSpPr>
          <p:cNvPr id="133" name="Group 193"/>
          <p:cNvGrpSpPr>
            <a:grpSpLocks/>
          </p:cNvGrpSpPr>
          <p:nvPr/>
        </p:nvGrpSpPr>
        <p:grpSpPr bwMode="auto">
          <a:xfrm>
            <a:off x="2479891" y="4732338"/>
            <a:ext cx="1310071" cy="47625"/>
            <a:chOff x="1532" y="2938"/>
            <a:chExt cx="825" cy="30"/>
          </a:xfrm>
        </p:grpSpPr>
        <p:sp>
          <p:nvSpPr>
            <p:cNvPr id="134" name="Rectangle 191"/>
            <p:cNvSpPr>
              <a:spLocks noChangeArrowheads="1"/>
            </p:cNvSpPr>
            <p:nvPr/>
          </p:nvSpPr>
          <p:spPr bwMode="auto">
            <a:xfrm>
              <a:off x="1532" y="2938"/>
              <a:ext cx="825" cy="30"/>
            </a:xfrm>
            <a:prstGeom prst="rect">
              <a:avLst/>
            </a:prstGeom>
            <a:solidFill>
              <a:srgbClr val="FF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  <p:sp>
          <p:nvSpPr>
            <p:cNvPr id="135" name="Rectangle 192"/>
            <p:cNvSpPr>
              <a:spLocks noChangeArrowheads="1"/>
            </p:cNvSpPr>
            <p:nvPr/>
          </p:nvSpPr>
          <p:spPr bwMode="auto">
            <a:xfrm>
              <a:off x="1532" y="2938"/>
              <a:ext cx="825" cy="30"/>
            </a:xfrm>
            <a:prstGeom prst="rect">
              <a:avLst/>
            </a:prstGeom>
            <a:noFill/>
            <a:ln w="4" cap="rnd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</p:grpSp>
      <p:grpSp>
        <p:nvGrpSpPr>
          <p:cNvPr id="136" name="Group 196"/>
          <p:cNvGrpSpPr>
            <a:grpSpLocks/>
          </p:cNvGrpSpPr>
          <p:nvPr/>
        </p:nvGrpSpPr>
        <p:grpSpPr bwMode="auto">
          <a:xfrm>
            <a:off x="3788375" y="4735513"/>
            <a:ext cx="184204" cy="46038"/>
            <a:chOff x="2356" y="2940"/>
            <a:chExt cx="116" cy="29"/>
          </a:xfrm>
        </p:grpSpPr>
        <p:sp>
          <p:nvSpPr>
            <p:cNvPr id="137" name="Rectangle 194"/>
            <p:cNvSpPr>
              <a:spLocks noChangeArrowheads="1"/>
            </p:cNvSpPr>
            <p:nvPr/>
          </p:nvSpPr>
          <p:spPr bwMode="auto">
            <a:xfrm>
              <a:off x="2356" y="2940"/>
              <a:ext cx="116" cy="29"/>
            </a:xfrm>
            <a:prstGeom prst="rect">
              <a:avLst/>
            </a:prstGeom>
            <a:solidFill>
              <a:srgbClr val="33CC33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  <p:sp>
          <p:nvSpPr>
            <p:cNvPr id="138" name="Rectangle 195"/>
            <p:cNvSpPr>
              <a:spLocks noChangeArrowheads="1"/>
            </p:cNvSpPr>
            <p:nvPr/>
          </p:nvSpPr>
          <p:spPr bwMode="auto">
            <a:xfrm>
              <a:off x="2356" y="2940"/>
              <a:ext cx="116" cy="29"/>
            </a:xfrm>
            <a:prstGeom prst="rect">
              <a:avLst/>
            </a:prstGeom>
            <a:noFill/>
            <a:ln w="4" cap="rnd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>
                <a:latin typeface="Calibri" pitchFamily="34" charset="0"/>
              </a:endParaRPr>
            </a:p>
          </p:txBody>
        </p:sp>
      </p:grpSp>
      <p:sp>
        <p:nvSpPr>
          <p:cNvPr id="139" name="Freeform 197"/>
          <p:cNvSpPr>
            <a:spLocks/>
          </p:cNvSpPr>
          <p:nvPr/>
        </p:nvSpPr>
        <p:spPr bwMode="auto">
          <a:xfrm>
            <a:off x="2498947" y="4854576"/>
            <a:ext cx="1452988" cy="103188"/>
          </a:xfrm>
          <a:custGeom>
            <a:avLst/>
            <a:gdLst>
              <a:gd name="T0" fmla="*/ 915 w 11900"/>
              <a:gd name="T1" fmla="*/ 0 h 825"/>
              <a:gd name="T2" fmla="*/ 839 w 11900"/>
              <a:gd name="T3" fmla="*/ 33 h 825"/>
              <a:gd name="T4" fmla="*/ 534 w 11900"/>
              <a:gd name="T5" fmla="*/ 33 h 825"/>
              <a:gd name="T6" fmla="*/ 458 w 11900"/>
              <a:gd name="T7" fmla="*/ 65 h 825"/>
              <a:gd name="T8" fmla="*/ 381 w 11900"/>
              <a:gd name="T9" fmla="*/ 33 h 825"/>
              <a:gd name="T10" fmla="*/ 76 w 11900"/>
              <a:gd name="T11" fmla="*/ 33 h 825"/>
              <a:gd name="T12" fmla="*/ 0 w 11900"/>
              <a:gd name="T13" fmla="*/ 0 h 825"/>
              <a:gd name="T14" fmla="*/ 0 60000 65536"/>
              <a:gd name="T15" fmla="*/ 0 60000 65536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w 11900"/>
              <a:gd name="T22" fmla="*/ 0 h 825"/>
              <a:gd name="T23" fmla="*/ 11900 w 11900"/>
              <a:gd name="T24" fmla="*/ 825 h 825"/>
            </a:gdLst>
            <a:ahLst/>
            <a:cxnLst>
              <a:cxn ang="T14">
                <a:pos x="T0" y="T1"/>
              </a:cxn>
              <a:cxn ang="T15">
                <a:pos x="T2" y="T3"/>
              </a:cxn>
              <a:cxn ang="T16">
                <a:pos x="T4" y="T5"/>
              </a:cxn>
              <a:cxn ang="T17">
                <a:pos x="T6" y="T7"/>
              </a:cxn>
              <a:cxn ang="T18">
                <a:pos x="T8" y="T9"/>
              </a:cxn>
              <a:cxn ang="T19">
                <a:pos x="T10" y="T11"/>
              </a:cxn>
              <a:cxn ang="T20">
                <a:pos x="T12" y="T13"/>
              </a:cxn>
            </a:cxnLst>
            <a:rect l="T21" t="T22" r="T23" b="T24"/>
            <a:pathLst>
              <a:path w="11900" h="825">
                <a:moveTo>
                  <a:pt x="11900" y="0"/>
                </a:moveTo>
                <a:cubicBezTo>
                  <a:pt x="11900" y="228"/>
                  <a:pt x="11456" y="413"/>
                  <a:pt x="10909" y="413"/>
                </a:cubicBezTo>
                <a:lnTo>
                  <a:pt x="6942" y="413"/>
                </a:lnTo>
                <a:cubicBezTo>
                  <a:pt x="6395" y="413"/>
                  <a:pt x="5950" y="597"/>
                  <a:pt x="5950" y="825"/>
                </a:cubicBezTo>
                <a:cubicBezTo>
                  <a:pt x="5950" y="597"/>
                  <a:pt x="5506" y="413"/>
                  <a:pt x="4959" y="413"/>
                </a:cubicBezTo>
                <a:lnTo>
                  <a:pt x="992" y="413"/>
                </a:lnTo>
                <a:cubicBezTo>
                  <a:pt x="445" y="413"/>
                  <a:pt x="0" y="228"/>
                  <a:pt x="0" y="0"/>
                </a:cubicBezTo>
              </a:path>
            </a:pathLst>
          </a:custGeom>
          <a:noFill/>
          <a:ln w="4" cap="rnd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40" name="Freeform 199"/>
          <p:cNvSpPr>
            <a:spLocks noEditPoints="1"/>
          </p:cNvSpPr>
          <p:nvPr/>
        </p:nvSpPr>
        <p:spPr bwMode="auto">
          <a:xfrm>
            <a:off x="3788375" y="4619626"/>
            <a:ext cx="166736" cy="50800"/>
          </a:xfrm>
          <a:custGeom>
            <a:avLst/>
            <a:gdLst>
              <a:gd name="T0" fmla="*/ 102 w 1358"/>
              <a:gd name="T1" fmla="*/ 19 h 400"/>
              <a:gd name="T2" fmla="*/ 26 w 1358"/>
              <a:gd name="T3" fmla="*/ 19 h 400"/>
              <a:gd name="T4" fmla="*/ 23 w 1358"/>
              <a:gd name="T5" fmla="*/ 16 h 400"/>
              <a:gd name="T6" fmla="*/ 26 w 1358"/>
              <a:gd name="T7" fmla="*/ 13 h 400"/>
              <a:gd name="T8" fmla="*/ 102 w 1358"/>
              <a:gd name="T9" fmla="*/ 13 h 400"/>
              <a:gd name="T10" fmla="*/ 105 w 1358"/>
              <a:gd name="T11" fmla="*/ 16 h 400"/>
              <a:gd name="T12" fmla="*/ 102 w 1358"/>
              <a:gd name="T13" fmla="*/ 19 h 400"/>
              <a:gd name="T14" fmla="*/ 31 w 1358"/>
              <a:gd name="T15" fmla="*/ 32 h 400"/>
              <a:gd name="T16" fmla="*/ 0 w 1358"/>
              <a:gd name="T17" fmla="*/ 16 h 400"/>
              <a:gd name="T18" fmla="*/ 31 w 1358"/>
              <a:gd name="T19" fmla="*/ 0 h 400"/>
              <a:gd name="T20" fmla="*/ 31 w 1358"/>
              <a:gd name="T21" fmla="*/ 32 h 400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60000 65536"/>
              <a:gd name="T31" fmla="*/ 0 60000 65536"/>
              <a:gd name="T32" fmla="*/ 0 60000 65536"/>
              <a:gd name="T33" fmla="*/ 0 w 1358"/>
              <a:gd name="T34" fmla="*/ 0 h 400"/>
              <a:gd name="T35" fmla="*/ 1358 w 1358"/>
              <a:gd name="T36" fmla="*/ 400 h 400"/>
            </a:gdLst>
            <a:ahLst/>
            <a:cxnLst>
              <a:cxn ang="T22">
                <a:pos x="T0" y="T1"/>
              </a:cxn>
              <a:cxn ang="T23">
                <a:pos x="T2" y="T3"/>
              </a:cxn>
              <a:cxn ang="T24">
                <a:pos x="T4" y="T5"/>
              </a:cxn>
              <a:cxn ang="T25">
                <a:pos x="T6" y="T7"/>
              </a:cxn>
              <a:cxn ang="T26">
                <a:pos x="T8" y="T9"/>
              </a:cxn>
              <a:cxn ang="T27">
                <a:pos x="T10" y="T11"/>
              </a:cxn>
              <a:cxn ang="T28">
                <a:pos x="T12" y="T13"/>
              </a:cxn>
              <a:cxn ang="T29">
                <a:pos x="T14" y="T15"/>
              </a:cxn>
              <a:cxn ang="T30">
                <a:pos x="T16" y="T17"/>
              </a:cxn>
              <a:cxn ang="T31">
                <a:pos x="T18" y="T19"/>
              </a:cxn>
              <a:cxn ang="T32">
                <a:pos x="T20" y="T21"/>
              </a:cxn>
            </a:cxnLst>
            <a:rect l="T33" t="T34" r="T35" b="T36"/>
            <a:pathLst>
              <a:path w="1358" h="400">
                <a:moveTo>
                  <a:pt x="1325" y="233"/>
                </a:moveTo>
                <a:lnTo>
                  <a:pt x="333" y="233"/>
                </a:lnTo>
                <a:cubicBezTo>
                  <a:pt x="315" y="233"/>
                  <a:pt x="300" y="218"/>
                  <a:pt x="300" y="200"/>
                </a:cubicBezTo>
                <a:cubicBezTo>
                  <a:pt x="300" y="181"/>
                  <a:pt x="315" y="166"/>
                  <a:pt x="333" y="166"/>
                </a:cubicBezTo>
                <a:lnTo>
                  <a:pt x="1325" y="166"/>
                </a:lnTo>
                <a:cubicBezTo>
                  <a:pt x="1344" y="166"/>
                  <a:pt x="1358" y="181"/>
                  <a:pt x="1358" y="200"/>
                </a:cubicBezTo>
                <a:cubicBezTo>
                  <a:pt x="1358" y="218"/>
                  <a:pt x="1344" y="233"/>
                  <a:pt x="1325" y="233"/>
                </a:cubicBezTo>
                <a:close/>
                <a:moveTo>
                  <a:pt x="400" y="400"/>
                </a:moveTo>
                <a:lnTo>
                  <a:pt x="0" y="200"/>
                </a:lnTo>
                <a:lnTo>
                  <a:pt x="400" y="0"/>
                </a:lnTo>
                <a:lnTo>
                  <a:pt x="400" y="40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41" name="Rectangle 202"/>
          <p:cNvSpPr>
            <a:spLocks noChangeArrowheads="1"/>
          </p:cNvSpPr>
          <p:nvPr/>
        </p:nvSpPr>
        <p:spPr bwMode="auto">
          <a:xfrm>
            <a:off x="6526027" y="2655888"/>
            <a:ext cx="28052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ank </a:t>
            </a:r>
            <a:endParaRPr lang="nl-N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Rectangle 203"/>
          <p:cNvSpPr>
            <a:spLocks noChangeArrowheads="1"/>
          </p:cNvSpPr>
          <p:nvPr/>
        </p:nvSpPr>
        <p:spPr bwMode="auto">
          <a:xfrm>
            <a:off x="6526027" y="2774951"/>
            <a:ext cx="57227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plification</a:t>
            </a:r>
            <a:endParaRPr lang="nl-N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Rectangle 204"/>
          <p:cNvSpPr>
            <a:spLocks noChangeArrowheads="1"/>
          </p:cNvSpPr>
          <p:nvPr/>
        </p:nvSpPr>
        <p:spPr bwMode="auto">
          <a:xfrm>
            <a:off x="6513323" y="3541713"/>
            <a:ext cx="9137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</a:t>
            </a:r>
            <a:endParaRPr lang="nl-NL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Rectangle 205"/>
          <p:cNvSpPr>
            <a:spLocks noChangeArrowheads="1"/>
          </p:cNvSpPr>
          <p:nvPr/>
        </p:nvSpPr>
        <p:spPr bwMode="auto">
          <a:xfrm>
            <a:off x="6595897" y="3541713"/>
            <a:ext cx="80986" cy="155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>
                <a:solidFill>
                  <a:srgbClr val="000000"/>
                </a:solidFill>
                <a:latin typeface="Trebuchet MS" pitchFamily="34" charset="0"/>
                <a:cs typeface="Arial" charset="0"/>
              </a:rPr>
              <a:t>-</a:t>
            </a:r>
            <a:endParaRPr lang="nl-NL">
              <a:cs typeface="Arial" charset="0"/>
            </a:endParaRPr>
          </a:p>
        </p:txBody>
      </p:sp>
      <p:sp>
        <p:nvSpPr>
          <p:cNvPr id="145" name="Rectangle 206"/>
          <p:cNvSpPr>
            <a:spLocks noChangeArrowheads="1"/>
          </p:cNvSpPr>
          <p:nvPr/>
        </p:nvSpPr>
        <p:spPr bwMode="auto">
          <a:xfrm>
            <a:off x="6630833" y="3541713"/>
            <a:ext cx="31579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tite</a:t>
            </a:r>
            <a:r>
              <a:rPr lang="nl-NL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nl-N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Rectangle 207"/>
          <p:cNvSpPr>
            <a:spLocks noChangeArrowheads="1"/>
          </p:cNvSpPr>
          <p:nvPr/>
        </p:nvSpPr>
        <p:spPr bwMode="auto">
          <a:xfrm>
            <a:off x="6513323" y="3662363"/>
            <a:ext cx="57227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plification</a:t>
            </a:r>
            <a:endParaRPr lang="nl-N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Rectangle 208"/>
          <p:cNvSpPr>
            <a:spLocks noChangeArrowheads="1"/>
          </p:cNvSpPr>
          <p:nvPr/>
        </p:nvSpPr>
        <p:spPr bwMode="auto">
          <a:xfrm>
            <a:off x="6580018" y="4610101"/>
            <a:ext cx="50975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erification</a:t>
            </a:r>
            <a:endParaRPr lang="nl-NL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Rectangle 12"/>
          <p:cNvSpPr>
            <a:spLocks noChangeArrowheads="1"/>
          </p:cNvSpPr>
          <p:nvPr/>
        </p:nvSpPr>
        <p:spPr bwMode="auto">
          <a:xfrm>
            <a:off x="5296942" y="3130303"/>
            <a:ext cx="406519" cy="123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r>
              <a:rPr lang="nl-NL" sz="800">
                <a:solidFill>
                  <a:srgbClr val="000000"/>
                </a:solidFill>
                <a:cs typeface="Arial" charset="0"/>
              </a:rPr>
              <a:t>1000 bp</a:t>
            </a:r>
            <a:endParaRPr lang="nl-NL">
              <a:cs typeface="Arial" charset="0"/>
            </a:endParaRPr>
          </a:p>
        </p:txBody>
      </p:sp>
      <p:sp>
        <p:nvSpPr>
          <p:cNvPr id="149" name="Rectangle 1"/>
          <p:cNvSpPr>
            <a:spLocks noChangeArrowheads="1"/>
          </p:cNvSpPr>
          <p:nvPr/>
        </p:nvSpPr>
        <p:spPr bwMode="auto">
          <a:xfrm>
            <a:off x="3939233" y="3471356"/>
            <a:ext cx="32412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1000" dirty="0" smtClean="0">
                <a:solidFill>
                  <a:srgbClr val="000000"/>
                </a:solidFill>
                <a:latin typeface="Trebuchet MS" pitchFamily="34" charset="0"/>
                <a:cs typeface="Arial" charset="0"/>
              </a:rPr>
              <a:t>P8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150" name="Rectangle 189"/>
          <p:cNvSpPr>
            <a:spLocks noChangeArrowheads="1"/>
          </p:cNvSpPr>
          <p:nvPr/>
        </p:nvSpPr>
        <p:spPr bwMode="auto">
          <a:xfrm>
            <a:off x="4175784" y="4119428"/>
            <a:ext cx="32422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1000">
                <a:solidFill>
                  <a:srgbClr val="000000"/>
                </a:solidFill>
                <a:latin typeface="Trebuchet MS" pitchFamily="34" charset="0"/>
                <a:cs typeface="Arial" charset="0"/>
              </a:rPr>
              <a:t>P9</a:t>
            </a:r>
            <a:endParaRPr lang="en-US">
              <a:latin typeface="Calibri" pitchFamily="34" charset="0"/>
            </a:endParaRPr>
          </a:p>
        </p:txBody>
      </p:sp>
      <p:sp>
        <p:nvSpPr>
          <p:cNvPr id="151" name="Rectangle 213"/>
          <p:cNvSpPr>
            <a:spLocks noChangeArrowheads="1"/>
          </p:cNvSpPr>
          <p:nvPr/>
        </p:nvSpPr>
        <p:spPr bwMode="auto">
          <a:xfrm>
            <a:off x="3707687" y="4437657"/>
            <a:ext cx="32422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1000" dirty="0" smtClean="0">
                <a:solidFill>
                  <a:srgbClr val="000000"/>
                </a:solidFill>
                <a:latin typeface="Trebuchet MS" pitchFamily="34" charset="0"/>
                <a:cs typeface="Arial" charset="0"/>
              </a:rPr>
              <a:t>P5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152" name="Rectangle 214"/>
          <p:cNvSpPr>
            <a:spLocks noChangeArrowheads="1"/>
          </p:cNvSpPr>
          <p:nvPr/>
        </p:nvSpPr>
        <p:spPr bwMode="auto">
          <a:xfrm>
            <a:off x="4427978" y="4437657"/>
            <a:ext cx="32412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1000" dirty="0" smtClean="0">
                <a:solidFill>
                  <a:srgbClr val="000000"/>
                </a:solidFill>
                <a:latin typeface="Trebuchet MS" pitchFamily="34" charset="0"/>
                <a:cs typeface="Arial" charset="0"/>
              </a:rPr>
              <a:t>P2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153" name="Rectangle 70"/>
          <p:cNvSpPr>
            <a:spLocks noChangeArrowheads="1"/>
          </p:cNvSpPr>
          <p:nvPr/>
        </p:nvSpPr>
        <p:spPr bwMode="auto">
          <a:xfrm>
            <a:off x="3828652" y="2221057"/>
            <a:ext cx="886461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700" dirty="0">
                <a:solidFill>
                  <a:srgbClr val="000000"/>
                </a:solidFill>
                <a:cs typeface="Arial" charset="0"/>
              </a:rPr>
              <a:t>Gene </a:t>
            </a:r>
            <a:r>
              <a:rPr lang="nl-NL" sz="700" dirty="0" err="1" smtClean="0">
                <a:solidFill>
                  <a:srgbClr val="000000"/>
                </a:solidFill>
                <a:cs typeface="Arial" charset="0"/>
              </a:rPr>
              <a:t>knock</a:t>
            </a:r>
            <a:r>
              <a:rPr lang="nl-NL" sz="700" dirty="0" smtClean="0">
                <a:solidFill>
                  <a:srgbClr val="000000"/>
                </a:solidFill>
                <a:cs typeface="Arial" charset="0"/>
              </a:rPr>
              <a:t> out target</a:t>
            </a:r>
            <a:endParaRPr lang="nl-NL" sz="700" dirty="0">
              <a:cs typeface="Arial" charset="0"/>
            </a:endParaRPr>
          </a:p>
        </p:txBody>
      </p:sp>
      <p:sp>
        <p:nvSpPr>
          <p:cNvPr id="154" name="Rectangle 139"/>
          <p:cNvSpPr>
            <a:spLocks noChangeArrowheads="1"/>
          </p:cNvSpPr>
          <p:nvPr/>
        </p:nvSpPr>
        <p:spPr bwMode="auto">
          <a:xfrm>
            <a:off x="5684406" y="4441093"/>
            <a:ext cx="36708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nl-NL" sz="1200" b="1" dirty="0" smtClean="0">
                <a:solidFill>
                  <a:srgbClr val="0000FF"/>
                </a:solidFill>
                <a:cs typeface="Arial" charset="0"/>
              </a:rPr>
              <a:t>P4T1</a:t>
            </a:r>
            <a:endParaRPr lang="nl-NL" dirty="0">
              <a:cs typeface="Arial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</Words>
  <Application>Microsoft Office PowerPoint</Application>
  <PresentationFormat>On-screen Show (4:3)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rebuchet MS</vt:lpstr>
      <vt:lpstr>Office Theme</vt:lpstr>
      <vt:lpstr>PowerPoint Presentation</vt:lpstr>
    </vt:vector>
  </TitlesOfParts>
  <Company>DS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endsen, Yvonne</dc:creator>
  <cp:lastModifiedBy>Arthur</cp:lastModifiedBy>
  <cp:revision>13</cp:revision>
  <cp:lastPrinted>2022-04-29T11:44:07Z</cp:lastPrinted>
  <dcterms:created xsi:type="dcterms:W3CDTF">2012-08-22T07:25:59Z</dcterms:created>
  <dcterms:modified xsi:type="dcterms:W3CDTF">2022-04-29T12:08:58Z</dcterms:modified>
</cp:coreProperties>
</file>